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6"/>
  </p:notesMasterIdLst>
  <p:sldIdLst>
    <p:sldId id="259" r:id="rId2"/>
    <p:sldId id="256" r:id="rId3"/>
    <p:sldId id="257" r:id="rId4"/>
    <p:sldId id="258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2" d="100"/>
          <a:sy n="122" d="100"/>
        </p:scale>
        <p:origin x="1546" y="101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D0A01E-26BE-4078-B8C4-DAC049EF1C95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E5BAFC-606A-4BB1-B4FB-38E0D31ABA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9932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E5BAFC-606A-4BB1-B4FB-38E0D31ABA0C}" type="slidenum">
              <a:rPr lang="ko-KR" altLang="en-US" smtClean="0"/>
              <a:t>1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80464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760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9980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6566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7538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5918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6325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124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000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7253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9109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6457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93633-E401-41AA-A203-B156D9E356A8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C01A81-2CB5-48FE-BA2F-2EE840F91B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9033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1.jpeg"/><Relationship Id="rId13" Type="http://schemas.openxmlformats.org/officeDocument/2006/relationships/image" Target="../media/image156.jpeg"/><Relationship Id="rId18" Type="http://schemas.openxmlformats.org/officeDocument/2006/relationships/image" Target="../media/image161.jpeg"/><Relationship Id="rId3" Type="http://schemas.openxmlformats.org/officeDocument/2006/relationships/image" Target="../media/image146.jpeg"/><Relationship Id="rId21" Type="http://schemas.openxmlformats.org/officeDocument/2006/relationships/image" Target="../media/image164.jpeg"/><Relationship Id="rId7" Type="http://schemas.openxmlformats.org/officeDocument/2006/relationships/image" Target="../media/image150.jpeg"/><Relationship Id="rId12" Type="http://schemas.openxmlformats.org/officeDocument/2006/relationships/image" Target="../media/image155.jpeg"/><Relationship Id="rId17" Type="http://schemas.openxmlformats.org/officeDocument/2006/relationships/image" Target="../media/image160.jpeg"/><Relationship Id="rId25" Type="http://schemas.openxmlformats.org/officeDocument/2006/relationships/image" Target="../media/image168.jpeg"/><Relationship Id="rId2" Type="http://schemas.openxmlformats.org/officeDocument/2006/relationships/image" Target="../media/image145.jpeg"/><Relationship Id="rId16" Type="http://schemas.openxmlformats.org/officeDocument/2006/relationships/image" Target="../media/image159.jpeg"/><Relationship Id="rId20" Type="http://schemas.openxmlformats.org/officeDocument/2006/relationships/image" Target="../media/image16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9.jpeg"/><Relationship Id="rId11" Type="http://schemas.openxmlformats.org/officeDocument/2006/relationships/image" Target="../media/image154.jpeg"/><Relationship Id="rId24" Type="http://schemas.openxmlformats.org/officeDocument/2006/relationships/image" Target="../media/image167.jpeg"/><Relationship Id="rId5" Type="http://schemas.openxmlformats.org/officeDocument/2006/relationships/image" Target="../media/image148.jpeg"/><Relationship Id="rId15" Type="http://schemas.openxmlformats.org/officeDocument/2006/relationships/image" Target="../media/image158.jpeg"/><Relationship Id="rId23" Type="http://schemas.openxmlformats.org/officeDocument/2006/relationships/image" Target="../media/image166.jpeg"/><Relationship Id="rId10" Type="http://schemas.openxmlformats.org/officeDocument/2006/relationships/image" Target="../media/image153.jpeg"/><Relationship Id="rId19" Type="http://schemas.openxmlformats.org/officeDocument/2006/relationships/image" Target="../media/image162.jpeg"/><Relationship Id="rId4" Type="http://schemas.openxmlformats.org/officeDocument/2006/relationships/image" Target="../media/image147.jpeg"/><Relationship Id="rId9" Type="http://schemas.openxmlformats.org/officeDocument/2006/relationships/image" Target="../media/image152.jpeg"/><Relationship Id="rId14" Type="http://schemas.openxmlformats.org/officeDocument/2006/relationships/image" Target="../media/image157.jpeg"/><Relationship Id="rId22" Type="http://schemas.openxmlformats.org/officeDocument/2006/relationships/image" Target="../media/image165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5.jpeg"/><Relationship Id="rId13" Type="http://schemas.openxmlformats.org/officeDocument/2006/relationships/image" Target="../media/image180.jpeg"/><Relationship Id="rId18" Type="http://schemas.openxmlformats.org/officeDocument/2006/relationships/image" Target="../media/image185.jpeg"/><Relationship Id="rId3" Type="http://schemas.openxmlformats.org/officeDocument/2006/relationships/image" Target="../media/image170.jpeg"/><Relationship Id="rId21" Type="http://schemas.openxmlformats.org/officeDocument/2006/relationships/image" Target="../media/image188.jpeg"/><Relationship Id="rId7" Type="http://schemas.openxmlformats.org/officeDocument/2006/relationships/image" Target="../media/image174.jpeg"/><Relationship Id="rId12" Type="http://schemas.openxmlformats.org/officeDocument/2006/relationships/image" Target="../media/image179.jpeg"/><Relationship Id="rId17" Type="http://schemas.openxmlformats.org/officeDocument/2006/relationships/image" Target="../media/image184.jpeg"/><Relationship Id="rId25" Type="http://schemas.openxmlformats.org/officeDocument/2006/relationships/image" Target="../media/image192.jpeg"/><Relationship Id="rId2" Type="http://schemas.openxmlformats.org/officeDocument/2006/relationships/image" Target="../media/image169.jpeg"/><Relationship Id="rId16" Type="http://schemas.openxmlformats.org/officeDocument/2006/relationships/image" Target="../media/image183.jpeg"/><Relationship Id="rId20" Type="http://schemas.openxmlformats.org/officeDocument/2006/relationships/image" Target="../media/image18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3.jpeg"/><Relationship Id="rId11" Type="http://schemas.openxmlformats.org/officeDocument/2006/relationships/image" Target="../media/image178.jpeg"/><Relationship Id="rId24" Type="http://schemas.openxmlformats.org/officeDocument/2006/relationships/image" Target="../media/image191.jpeg"/><Relationship Id="rId5" Type="http://schemas.openxmlformats.org/officeDocument/2006/relationships/image" Target="../media/image172.jpeg"/><Relationship Id="rId15" Type="http://schemas.openxmlformats.org/officeDocument/2006/relationships/image" Target="../media/image182.jpeg"/><Relationship Id="rId23" Type="http://schemas.openxmlformats.org/officeDocument/2006/relationships/image" Target="../media/image190.jpeg"/><Relationship Id="rId10" Type="http://schemas.openxmlformats.org/officeDocument/2006/relationships/image" Target="../media/image177.jpeg"/><Relationship Id="rId19" Type="http://schemas.openxmlformats.org/officeDocument/2006/relationships/image" Target="../media/image186.jpeg"/><Relationship Id="rId4" Type="http://schemas.openxmlformats.org/officeDocument/2006/relationships/image" Target="../media/image171.jpeg"/><Relationship Id="rId9" Type="http://schemas.openxmlformats.org/officeDocument/2006/relationships/image" Target="../media/image176.jpeg"/><Relationship Id="rId14" Type="http://schemas.openxmlformats.org/officeDocument/2006/relationships/image" Target="../media/image181.jpeg"/><Relationship Id="rId22" Type="http://schemas.openxmlformats.org/officeDocument/2006/relationships/image" Target="../media/image189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9.jpeg"/><Relationship Id="rId13" Type="http://schemas.openxmlformats.org/officeDocument/2006/relationships/image" Target="../media/image204.jpeg"/><Relationship Id="rId18" Type="http://schemas.openxmlformats.org/officeDocument/2006/relationships/image" Target="../media/image209.jpeg"/><Relationship Id="rId3" Type="http://schemas.openxmlformats.org/officeDocument/2006/relationships/image" Target="../media/image194.jpeg"/><Relationship Id="rId21" Type="http://schemas.openxmlformats.org/officeDocument/2006/relationships/image" Target="../media/image212.jpeg"/><Relationship Id="rId7" Type="http://schemas.openxmlformats.org/officeDocument/2006/relationships/image" Target="../media/image198.jpeg"/><Relationship Id="rId12" Type="http://schemas.openxmlformats.org/officeDocument/2006/relationships/image" Target="../media/image203.jpeg"/><Relationship Id="rId17" Type="http://schemas.openxmlformats.org/officeDocument/2006/relationships/image" Target="../media/image208.jpeg"/><Relationship Id="rId25" Type="http://schemas.openxmlformats.org/officeDocument/2006/relationships/image" Target="../media/image216.jpeg"/><Relationship Id="rId2" Type="http://schemas.openxmlformats.org/officeDocument/2006/relationships/image" Target="../media/image193.jpeg"/><Relationship Id="rId16" Type="http://schemas.openxmlformats.org/officeDocument/2006/relationships/image" Target="../media/image207.jpeg"/><Relationship Id="rId20" Type="http://schemas.openxmlformats.org/officeDocument/2006/relationships/image" Target="../media/image21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7.jpeg"/><Relationship Id="rId11" Type="http://schemas.openxmlformats.org/officeDocument/2006/relationships/image" Target="../media/image202.jpeg"/><Relationship Id="rId24" Type="http://schemas.openxmlformats.org/officeDocument/2006/relationships/image" Target="../media/image215.jpeg"/><Relationship Id="rId5" Type="http://schemas.openxmlformats.org/officeDocument/2006/relationships/image" Target="../media/image196.jpeg"/><Relationship Id="rId15" Type="http://schemas.openxmlformats.org/officeDocument/2006/relationships/image" Target="../media/image206.jpeg"/><Relationship Id="rId23" Type="http://schemas.openxmlformats.org/officeDocument/2006/relationships/image" Target="../media/image214.jpeg"/><Relationship Id="rId10" Type="http://schemas.openxmlformats.org/officeDocument/2006/relationships/image" Target="../media/image201.jpeg"/><Relationship Id="rId19" Type="http://schemas.openxmlformats.org/officeDocument/2006/relationships/image" Target="../media/image210.jpeg"/><Relationship Id="rId4" Type="http://schemas.openxmlformats.org/officeDocument/2006/relationships/image" Target="../media/image195.jpeg"/><Relationship Id="rId9" Type="http://schemas.openxmlformats.org/officeDocument/2006/relationships/image" Target="../media/image200.jpeg"/><Relationship Id="rId14" Type="http://schemas.openxmlformats.org/officeDocument/2006/relationships/image" Target="../media/image205.jpeg"/><Relationship Id="rId22" Type="http://schemas.openxmlformats.org/officeDocument/2006/relationships/image" Target="../media/image213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8.jpeg"/><Relationship Id="rId7" Type="http://schemas.openxmlformats.org/officeDocument/2006/relationships/image" Target="../media/image222.jpeg"/><Relationship Id="rId2" Type="http://schemas.openxmlformats.org/officeDocument/2006/relationships/image" Target="../media/image2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1.jpeg"/><Relationship Id="rId5" Type="http://schemas.openxmlformats.org/officeDocument/2006/relationships/image" Target="../media/image220.jpeg"/><Relationship Id="rId4" Type="http://schemas.openxmlformats.org/officeDocument/2006/relationships/image" Target="../media/image219.jpe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9.jpeg"/><Relationship Id="rId13" Type="http://schemas.openxmlformats.org/officeDocument/2006/relationships/image" Target="../media/image234.png"/><Relationship Id="rId3" Type="http://schemas.openxmlformats.org/officeDocument/2006/relationships/image" Target="../media/image224.jpeg"/><Relationship Id="rId7" Type="http://schemas.openxmlformats.org/officeDocument/2006/relationships/image" Target="../media/image228.jpeg"/><Relationship Id="rId12" Type="http://schemas.openxmlformats.org/officeDocument/2006/relationships/image" Target="../media/image233.jpeg"/><Relationship Id="rId2" Type="http://schemas.openxmlformats.org/officeDocument/2006/relationships/image" Target="../media/image22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7.jpeg"/><Relationship Id="rId11" Type="http://schemas.openxmlformats.org/officeDocument/2006/relationships/image" Target="../media/image232.jpeg"/><Relationship Id="rId5" Type="http://schemas.openxmlformats.org/officeDocument/2006/relationships/image" Target="../media/image226.jpeg"/><Relationship Id="rId10" Type="http://schemas.openxmlformats.org/officeDocument/2006/relationships/image" Target="../media/image231.png"/><Relationship Id="rId4" Type="http://schemas.openxmlformats.org/officeDocument/2006/relationships/image" Target="../media/image225.jpeg"/><Relationship Id="rId9" Type="http://schemas.openxmlformats.org/officeDocument/2006/relationships/image" Target="../media/image230.jpe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1.jpeg"/><Relationship Id="rId13" Type="http://schemas.openxmlformats.org/officeDocument/2006/relationships/image" Target="../media/image246.jpeg"/><Relationship Id="rId3" Type="http://schemas.openxmlformats.org/officeDocument/2006/relationships/image" Target="../media/image236.jpeg"/><Relationship Id="rId7" Type="http://schemas.openxmlformats.org/officeDocument/2006/relationships/image" Target="../media/image240.jpeg"/><Relationship Id="rId12" Type="http://schemas.openxmlformats.org/officeDocument/2006/relationships/image" Target="../media/image245.jpeg"/><Relationship Id="rId2" Type="http://schemas.openxmlformats.org/officeDocument/2006/relationships/image" Target="../media/image23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9.jpeg"/><Relationship Id="rId11" Type="http://schemas.openxmlformats.org/officeDocument/2006/relationships/image" Target="../media/image244.jpeg"/><Relationship Id="rId5" Type="http://schemas.openxmlformats.org/officeDocument/2006/relationships/image" Target="../media/image238.jpeg"/><Relationship Id="rId10" Type="http://schemas.openxmlformats.org/officeDocument/2006/relationships/image" Target="../media/image243.jpeg"/><Relationship Id="rId4" Type="http://schemas.openxmlformats.org/officeDocument/2006/relationships/image" Target="../media/image237.jpeg"/><Relationship Id="rId9" Type="http://schemas.openxmlformats.org/officeDocument/2006/relationships/image" Target="../media/image242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2.jpeg"/><Relationship Id="rId13" Type="http://schemas.openxmlformats.org/officeDocument/2006/relationships/image" Target="../media/image257.jpeg"/><Relationship Id="rId3" Type="http://schemas.openxmlformats.org/officeDocument/2006/relationships/image" Target="../media/image247.jpeg"/><Relationship Id="rId7" Type="http://schemas.openxmlformats.org/officeDocument/2006/relationships/image" Target="../media/image251.jpeg"/><Relationship Id="rId12" Type="http://schemas.openxmlformats.org/officeDocument/2006/relationships/image" Target="../media/image256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0.jpeg"/><Relationship Id="rId11" Type="http://schemas.openxmlformats.org/officeDocument/2006/relationships/image" Target="../media/image255.jpeg"/><Relationship Id="rId5" Type="http://schemas.openxmlformats.org/officeDocument/2006/relationships/image" Target="../media/image249.jpeg"/><Relationship Id="rId10" Type="http://schemas.openxmlformats.org/officeDocument/2006/relationships/image" Target="../media/image254.jpeg"/><Relationship Id="rId4" Type="http://schemas.openxmlformats.org/officeDocument/2006/relationships/image" Target="../media/image248.jpeg"/><Relationship Id="rId9" Type="http://schemas.openxmlformats.org/officeDocument/2006/relationships/image" Target="../media/image253.jpeg"/><Relationship Id="rId14" Type="http://schemas.openxmlformats.org/officeDocument/2006/relationships/image" Target="../media/image258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0.jpeg"/><Relationship Id="rId2" Type="http://schemas.openxmlformats.org/officeDocument/2006/relationships/image" Target="../media/image259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61.jpe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8.jpeg"/><Relationship Id="rId13" Type="http://schemas.openxmlformats.org/officeDocument/2006/relationships/image" Target="../media/image273.jpeg"/><Relationship Id="rId3" Type="http://schemas.openxmlformats.org/officeDocument/2006/relationships/image" Target="../media/image263.jpeg"/><Relationship Id="rId7" Type="http://schemas.openxmlformats.org/officeDocument/2006/relationships/image" Target="../media/image267.jpeg"/><Relationship Id="rId12" Type="http://schemas.openxmlformats.org/officeDocument/2006/relationships/image" Target="../media/image272.jpeg"/><Relationship Id="rId2" Type="http://schemas.openxmlformats.org/officeDocument/2006/relationships/image" Target="../media/image26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6.jpeg"/><Relationship Id="rId11" Type="http://schemas.openxmlformats.org/officeDocument/2006/relationships/image" Target="../media/image271.jpeg"/><Relationship Id="rId5" Type="http://schemas.openxmlformats.org/officeDocument/2006/relationships/image" Target="../media/image265.jpeg"/><Relationship Id="rId10" Type="http://schemas.openxmlformats.org/officeDocument/2006/relationships/image" Target="../media/image270.jpeg"/><Relationship Id="rId4" Type="http://schemas.openxmlformats.org/officeDocument/2006/relationships/image" Target="../media/image264.jpeg"/><Relationship Id="rId9" Type="http://schemas.openxmlformats.org/officeDocument/2006/relationships/image" Target="../media/image269.jpe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0.jpeg"/><Relationship Id="rId13" Type="http://schemas.openxmlformats.org/officeDocument/2006/relationships/image" Target="../media/image285.jpeg"/><Relationship Id="rId3" Type="http://schemas.openxmlformats.org/officeDocument/2006/relationships/image" Target="../media/image275.jpeg"/><Relationship Id="rId7" Type="http://schemas.openxmlformats.org/officeDocument/2006/relationships/image" Target="../media/image279.jpeg"/><Relationship Id="rId12" Type="http://schemas.openxmlformats.org/officeDocument/2006/relationships/image" Target="../media/image284.jpeg"/><Relationship Id="rId2" Type="http://schemas.openxmlformats.org/officeDocument/2006/relationships/image" Target="../media/image27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8.jpeg"/><Relationship Id="rId11" Type="http://schemas.openxmlformats.org/officeDocument/2006/relationships/image" Target="../media/image283.jpeg"/><Relationship Id="rId5" Type="http://schemas.openxmlformats.org/officeDocument/2006/relationships/image" Target="../media/image277.jpeg"/><Relationship Id="rId10" Type="http://schemas.openxmlformats.org/officeDocument/2006/relationships/image" Target="../media/image282.jpeg"/><Relationship Id="rId4" Type="http://schemas.openxmlformats.org/officeDocument/2006/relationships/image" Target="../media/image276.jpeg"/><Relationship Id="rId9" Type="http://schemas.openxmlformats.org/officeDocument/2006/relationships/image" Target="../media/image281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2.jpeg"/><Relationship Id="rId13" Type="http://schemas.openxmlformats.org/officeDocument/2006/relationships/image" Target="../media/image297.jpeg"/><Relationship Id="rId3" Type="http://schemas.openxmlformats.org/officeDocument/2006/relationships/image" Target="../media/image287.jpeg"/><Relationship Id="rId7" Type="http://schemas.openxmlformats.org/officeDocument/2006/relationships/image" Target="../media/image291.jpeg"/><Relationship Id="rId12" Type="http://schemas.openxmlformats.org/officeDocument/2006/relationships/image" Target="../media/image296.jpeg"/><Relationship Id="rId2" Type="http://schemas.openxmlformats.org/officeDocument/2006/relationships/image" Target="../media/image28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0.jpeg"/><Relationship Id="rId11" Type="http://schemas.openxmlformats.org/officeDocument/2006/relationships/image" Target="../media/image295.jpeg"/><Relationship Id="rId5" Type="http://schemas.openxmlformats.org/officeDocument/2006/relationships/image" Target="../media/image289.jpeg"/><Relationship Id="rId10" Type="http://schemas.openxmlformats.org/officeDocument/2006/relationships/image" Target="../media/image294.jpeg"/><Relationship Id="rId4" Type="http://schemas.openxmlformats.org/officeDocument/2006/relationships/image" Target="../media/image288.jpeg"/><Relationship Id="rId9" Type="http://schemas.openxmlformats.org/officeDocument/2006/relationships/image" Target="../media/image293.jpe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9.jpeg"/><Relationship Id="rId2" Type="http://schemas.openxmlformats.org/officeDocument/2006/relationships/image" Target="../media/image29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2.jpeg"/><Relationship Id="rId5" Type="http://schemas.openxmlformats.org/officeDocument/2006/relationships/image" Target="../media/image301.jpeg"/><Relationship Id="rId4" Type="http://schemas.openxmlformats.org/officeDocument/2006/relationships/image" Target="../media/image300.jpe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9.jpeg"/><Relationship Id="rId3" Type="http://schemas.openxmlformats.org/officeDocument/2006/relationships/image" Target="../media/image304.jpeg"/><Relationship Id="rId7" Type="http://schemas.openxmlformats.org/officeDocument/2006/relationships/image" Target="../media/image308.jpeg"/><Relationship Id="rId2" Type="http://schemas.openxmlformats.org/officeDocument/2006/relationships/image" Target="../media/image30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7.jpeg"/><Relationship Id="rId5" Type="http://schemas.openxmlformats.org/officeDocument/2006/relationships/image" Target="../media/image306.jpeg"/><Relationship Id="rId10" Type="http://schemas.openxmlformats.org/officeDocument/2006/relationships/image" Target="../media/image311.jpeg"/><Relationship Id="rId4" Type="http://schemas.openxmlformats.org/officeDocument/2006/relationships/image" Target="../media/image305.jpeg"/><Relationship Id="rId9" Type="http://schemas.openxmlformats.org/officeDocument/2006/relationships/image" Target="../media/image310.jpeg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8.jpeg"/><Relationship Id="rId3" Type="http://schemas.openxmlformats.org/officeDocument/2006/relationships/image" Target="../media/image313.jpeg"/><Relationship Id="rId7" Type="http://schemas.openxmlformats.org/officeDocument/2006/relationships/image" Target="../media/image317.jpeg"/><Relationship Id="rId2" Type="http://schemas.openxmlformats.org/officeDocument/2006/relationships/image" Target="../media/image31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6.jpeg"/><Relationship Id="rId5" Type="http://schemas.openxmlformats.org/officeDocument/2006/relationships/image" Target="../media/image315.jpeg"/><Relationship Id="rId10" Type="http://schemas.openxmlformats.org/officeDocument/2006/relationships/image" Target="../media/image320.jpeg"/><Relationship Id="rId4" Type="http://schemas.openxmlformats.org/officeDocument/2006/relationships/image" Target="../media/image314.jpeg"/><Relationship Id="rId9" Type="http://schemas.openxmlformats.org/officeDocument/2006/relationships/image" Target="../media/image319.jpe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7.jpeg"/><Relationship Id="rId3" Type="http://schemas.openxmlformats.org/officeDocument/2006/relationships/image" Target="../media/image322.jpeg"/><Relationship Id="rId7" Type="http://schemas.openxmlformats.org/officeDocument/2006/relationships/image" Target="../media/image326.jpeg"/><Relationship Id="rId2" Type="http://schemas.openxmlformats.org/officeDocument/2006/relationships/image" Target="../media/image32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5.jpeg"/><Relationship Id="rId5" Type="http://schemas.openxmlformats.org/officeDocument/2006/relationships/image" Target="../media/image324.jpeg"/><Relationship Id="rId10" Type="http://schemas.openxmlformats.org/officeDocument/2006/relationships/image" Target="../media/image329.jpeg"/><Relationship Id="rId4" Type="http://schemas.openxmlformats.org/officeDocument/2006/relationships/image" Target="../media/image323.jpeg"/><Relationship Id="rId9" Type="http://schemas.openxmlformats.org/officeDocument/2006/relationships/image" Target="../media/image32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eg"/><Relationship Id="rId13" Type="http://schemas.openxmlformats.org/officeDocument/2006/relationships/image" Target="../media/image36.jpeg"/><Relationship Id="rId18" Type="http://schemas.openxmlformats.org/officeDocument/2006/relationships/image" Target="../media/image41.jpeg"/><Relationship Id="rId3" Type="http://schemas.openxmlformats.org/officeDocument/2006/relationships/image" Target="../media/image26.jpeg"/><Relationship Id="rId21" Type="http://schemas.openxmlformats.org/officeDocument/2006/relationships/image" Target="../media/image44.jpeg"/><Relationship Id="rId7" Type="http://schemas.openxmlformats.org/officeDocument/2006/relationships/image" Target="../media/image30.jpeg"/><Relationship Id="rId12" Type="http://schemas.openxmlformats.org/officeDocument/2006/relationships/image" Target="../media/image35.jpeg"/><Relationship Id="rId17" Type="http://schemas.openxmlformats.org/officeDocument/2006/relationships/image" Target="../media/image40.jpeg"/><Relationship Id="rId25" Type="http://schemas.openxmlformats.org/officeDocument/2006/relationships/image" Target="../media/image48.jpeg"/><Relationship Id="rId2" Type="http://schemas.openxmlformats.org/officeDocument/2006/relationships/image" Target="../media/image25.jpeg"/><Relationship Id="rId16" Type="http://schemas.openxmlformats.org/officeDocument/2006/relationships/image" Target="../media/image39.jpeg"/><Relationship Id="rId20" Type="http://schemas.openxmlformats.org/officeDocument/2006/relationships/image" Target="../media/image4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jpeg"/><Relationship Id="rId11" Type="http://schemas.openxmlformats.org/officeDocument/2006/relationships/image" Target="../media/image34.jpeg"/><Relationship Id="rId24" Type="http://schemas.openxmlformats.org/officeDocument/2006/relationships/image" Target="../media/image47.jpeg"/><Relationship Id="rId5" Type="http://schemas.openxmlformats.org/officeDocument/2006/relationships/image" Target="../media/image28.jpeg"/><Relationship Id="rId15" Type="http://schemas.openxmlformats.org/officeDocument/2006/relationships/image" Target="../media/image38.jpeg"/><Relationship Id="rId23" Type="http://schemas.openxmlformats.org/officeDocument/2006/relationships/image" Target="../media/image46.jpeg"/><Relationship Id="rId10" Type="http://schemas.openxmlformats.org/officeDocument/2006/relationships/image" Target="../media/image33.jpeg"/><Relationship Id="rId19" Type="http://schemas.openxmlformats.org/officeDocument/2006/relationships/image" Target="../media/image42.jpeg"/><Relationship Id="rId4" Type="http://schemas.openxmlformats.org/officeDocument/2006/relationships/image" Target="../media/image27.jpeg"/><Relationship Id="rId9" Type="http://schemas.openxmlformats.org/officeDocument/2006/relationships/image" Target="../media/image32.jpeg"/><Relationship Id="rId14" Type="http://schemas.openxmlformats.org/officeDocument/2006/relationships/image" Target="../media/image37.jpeg"/><Relationship Id="rId22" Type="http://schemas.openxmlformats.org/officeDocument/2006/relationships/image" Target="../media/image45.jpeg"/></Relationships>
</file>

<file path=ppt/slides/_rels/slide4.xml.rels><?xml version="1.0" encoding="UTF-8" standalone="yes"?>
<Relationships xmlns="http://schemas.openxmlformats.org/package/2006/relationships"><Relationship Id="rId13" Type="http://schemas.microsoft.com/office/2007/relationships/hdphoto" Target="../media/hdphoto4.wdp"/><Relationship Id="rId18" Type="http://schemas.openxmlformats.org/officeDocument/2006/relationships/image" Target="../media/image59.jpeg"/><Relationship Id="rId26" Type="http://schemas.microsoft.com/office/2007/relationships/hdphoto" Target="../media/hdphoto8.wdp"/><Relationship Id="rId21" Type="http://schemas.openxmlformats.org/officeDocument/2006/relationships/image" Target="../media/image62.jpeg"/><Relationship Id="rId34" Type="http://schemas.microsoft.com/office/2007/relationships/hdphoto" Target="../media/hdphoto11.wdp"/><Relationship Id="rId7" Type="http://schemas.microsoft.com/office/2007/relationships/hdphoto" Target="../media/hdphoto2.wdp"/><Relationship Id="rId12" Type="http://schemas.openxmlformats.org/officeDocument/2006/relationships/image" Target="../media/image56.jpeg"/><Relationship Id="rId17" Type="http://schemas.microsoft.com/office/2007/relationships/hdphoto" Target="../media/hdphoto6.wdp"/><Relationship Id="rId25" Type="http://schemas.openxmlformats.org/officeDocument/2006/relationships/image" Target="../media/image65.jpeg"/><Relationship Id="rId33" Type="http://schemas.openxmlformats.org/officeDocument/2006/relationships/image" Target="../media/image70.jpeg"/><Relationship Id="rId2" Type="http://schemas.openxmlformats.org/officeDocument/2006/relationships/image" Target="../media/image49.jpeg"/><Relationship Id="rId16" Type="http://schemas.openxmlformats.org/officeDocument/2006/relationships/image" Target="../media/image58.jpeg"/><Relationship Id="rId20" Type="http://schemas.openxmlformats.org/officeDocument/2006/relationships/image" Target="../media/image61.jpeg"/><Relationship Id="rId29" Type="http://schemas.openxmlformats.org/officeDocument/2006/relationships/image" Target="../media/image6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2.jpeg"/><Relationship Id="rId11" Type="http://schemas.openxmlformats.org/officeDocument/2006/relationships/image" Target="../media/image55.jpeg"/><Relationship Id="rId24" Type="http://schemas.openxmlformats.org/officeDocument/2006/relationships/image" Target="../media/image64.jpeg"/><Relationship Id="rId32" Type="http://schemas.openxmlformats.org/officeDocument/2006/relationships/image" Target="../media/image69.jpeg"/><Relationship Id="rId37" Type="http://schemas.microsoft.com/office/2007/relationships/hdphoto" Target="../media/hdphoto12.wdp"/><Relationship Id="rId5" Type="http://schemas.openxmlformats.org/officeDocument/2006/relationships/image" Target="../media/image51.jpeg"/><Relationship Id="rId15" Type="http://schemas.microsoft.com/office/2007/relationships/hdphoto" Target="../media/hdphoto5.wdp"/><Relationship Id="rId23" Type="http://schemas.openxmlformats.org/officeDocument/2006/relationships/image" Target="../media/image63.jpeg"/><Relationship Id="rId28" Type="http://schemas.microsoft.com/office/2007/relationships/hdphoto" Target="../media/hdphoto9.wdp"/><Relationship Id="rId36" Type="http://schemas.openxmlformats.org/officeDocument/2006/relationships/image" Target="../media/image72.jpeg"/><Relationship Id="rId10" Type="http://schemas.microsoft.com/office/2007/relationships/hdphoto" Target="../media/hdphoto3.wdp"/><Relationship Id="rId19" Type="http://schemas.openxmlformats.org/officeDocument/2006/relationships/image" Target="../media/image60.jpeg"/><Relationship Id="rId31" Type="http://schemas.microsoft.com/office/2007/relationships/hdphoto" Target="../media/hdphoto10.wdp"/><Relationship Id="rId4" Type="http://schemas.microsoft.com/office/2007/relationships/hdphoto" Target="../media/hdphoto1.wdp"/><Relationship Id="rId9" Type="http://schemas.openxmlformats.org/officeDocument/2006/relationships/image" Target="../media/image54.jpeg"/><Relationship Id="rId14" Type="http://schemas.openxmlformats.org/officeDocument/2006/relationships/image" Target="../media/image57.jpeg"/><Relationship Id="rId22" Type="http://schemas.microsoft.com/office/2007/relationships/hdphoto" Target="../media/hdphoto7.wdp"/><Relationship Id="rId27" Type="http://schemas.openxmlformats.org/officeDocument/2006/relationships/image" Target="../media/image66.jpeg"/><Relationship Id="rId30" Type="http://schemas.openxmlformats.org/officeDocument/2006/relationships/image" Target="../media/image68.jpeg"/><Relationship Id="rId35" Type="http://schemas.openxmlformats.org/officeDocument/2006/relationships/image" Target="../media/image71.jpeg"/><Relationship Id="rId8" Type="http://schemas.openxmlformats.org/officeDocument/2006/relationships/image" Target="../media/image53.jpeg"/><Relationship Id="rId3" Type="http://schemas.openxmlformats.org/officeDocument/2006/relationships/image" Target="../media/image50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2.jpeg"/><Relationship Id="rId18" Type="http://schemas.openxmlformats.org/officeDocument/2006/relationships/image" Target="../media/image85.jpeg"/><Relationship Id="rId26" Type="http://schemas.microsoft.com/office/2007/relationships/hdphoto" Target="../media/hdphoto20.wdp"/><Relationship Id="rId3" Type="http://schemas.openxmlformats.org/officeDocument/2006/relationships/image" Target="../media/image74.jpeg"/><Relationship Id="rId21" Type="http://schemas.openxmlformats.org/officeDocument/2006/relationships/image" Target="../media/image87.jpeg"/><Relationship Id="rId34" Type="http://schemas.openxmlformats.org/officeDocument/2006/relationships/image" Target="../media/image95.jpeg"/><Relationship Id="rId7" Type="http://schemas.microsoft.com/office/2007/relationships/hdphoto" Target="../media/hdphoto14.wdp"/><Relationship Id="rId12" Type="http://schemas.openxmlformats.org/officeDocument/2006/relationships/image" Target="../media/image81.jpeg"/><Relationship Id="rId17" Type="http://schemas.microsoft.com/office/2007/relationships/hdphoto" Target="../media/hdphoto16.wdp"/><Relationship Id="rId25" Type="http://schemas.openxmlformats.org/officeDocument/2006/relationships/image" Target="../media/image89.jpeg"/><Relationship Id="rId33" Type="http://schemas.openxmlformats.org/officeDocument/2006/relationships/image" Target="../media/image94.jpeg"/><Relationship Id="rId2" Type="http://schemas.openxmlformats.org/officeDocument/2006/relationships/image" Target="../media/image73.jpeg"/><Relationship Id="rId16" Type="http://schemas.openxmlformats.org/officeDocument/2006/relationships/image" Target="../media/image84.jpeg"/><Relationship Id="rId20" Type="http://schemas.microsoft.com/office/2007/relationships/hdphoto" Target="../media/hdphoto17.wdp"/><Relationship Id="rId29" Type="http://schemas.openxmlformats.org/officeDocument/2006/relationships/image" Target="../media/image9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6.jpeg"/><Relationship Id="rId11" Type="http://schemas.openxmlformats.org/officeDocument/2006/relationships/image" Target="../media/image80.jpeg"/><Relationship Id="rId24" Type="http://schemas.microsoft.com/office/2007/relationships/hdphoto" Target="../media/hdphoto19.wdp"/><Relationship Id="rId32" Type="http://schemas.microsoft.com/office/2007/relationships/hdphoto" Target="../media/hdphoto22.wdp"/><Relationship Id="rId5" Type="http://schemas.microsoft.com/office/2007/relationships/hdphoto" Target="../media/hdphoto13.wdp"/><Relationship Id="rId15" Type="http://schemas.microsoft.com/office/2007/relationships/hdphoto" Target="../media/hdphoto15.wdp"/><Relationship Id="rId23" Type="http://schemas.openxmlformats.org/officeDocument/2006/relationships/image" Target="../media/image88.jpeg"/><Relationship Id="rId28" Type="http://schemas.openxmlformats.org/officeDocument/2006/relationships/image" Target="../media/image91.jpeg"/><Relationship Id="rId10" Type="http://schemas.openxmlformats.org/officeDocument/2006/relationships/image" Target="../media/image79.jpeg"/><Relationship Id="rId19" Type="http://schemas.openxmlformats.org/officeDocument/2006/relationships/image" Target="../media/image86.jpeg"/><Relationship Id="rId31" Type="http://schemas.openxmlformats.org/officeDocument/2006/relationships/image" Target="../media/image93.jpeg"/><Relationship Id="rId4" Type="http://schemas.openxmlformats.org/officeDocument/2006/relationships/image" Target="../media/image75.jpeg"/><Relationship Id="rId9" Type="http://schemas.openxmlformats.org/officeDocument/2006/relationships/image" Target="../media/image78.jpeg"/><Relationship Id="rId14" Type="http://schemas.openxmlformats.org/officeDocument/2006/relationships/image" Target="../media/image83.jpeg"/><Relationship Id="rId22" Type="http://schemas.microsoft.com/office/2007/relationships/hdphoto" Target="../media/hdphoto18.wdp"/><Relationship Id="rId27" Type="http://schemas.openxmlformats.org/officeDocument/2006/relationships/image" Target="../media/image90.jpeg"/><Relationship Id="rId30" Type="http://schemas.microsoft.com/office/2007/relationships/hdphoto" Target="../media/hdphoto21.wdp"/><Relationship Id="rId35" Type="http://schemas.openxmlformats.org/officeDocument/2006/relationships/image" Target="../media/image96.jpeg"/><Relationship Id="rId8" Type="http://schemas.openxmlformats.org/officeDocument/2006/relationships/image" Target="../media/image77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2.jpeg"/><Relationship Id="rId13" Type="http://schemas.openxmlformats.org/officeDocument/2006/relationships/image" Target="../media/image107.jpeg"/><Relationship Id="rId18" Type="http://schemas.microsoft.com/office/2007/relationships/hdphoto" Target="../media/hdphoto24.wdp"/><Relationship Id="rId26" Type="http://schemas.openxmlformats.org/officeDocument/2006/relationships/image" Target="../media/image118.jpeg"/><Relationship Id="rId3" Type="http://schemas.microsoft.com/office/2007/relationships/hdphoto" Target="../media/hdphoto23.wdp"/><Relationship Id="rId21" Type="http://schemas.microsoft.com/office/2007/relationships/hdphoto" Target="../media/hdphoto25.wdp"/><Relationship Id="rId7" Type="http://schemas.openxmlformats.org/officeDocument/2006/relationships/image" Target="../media/image101.jpeg"/><Relationship Id="rId12" Type="http://schemas.openxmlformats.org/officeDocument/2006/relationships/image" Target="../media/image106.jpeg"/><Relationship Id="rId17" Type="http://schemas.openxmlformats.org/officeDocument/2006/relationships/image" Target="../media/image111.jpeg"/><Relationship Id="rId25" Type="http://schemas.openxmlformats.org/officeDocument/2006/relationships/image" Target="../media/image117.jpeg"/><Relationship Id="rId2" Type="http://schemas.openxmlformats.org/officeDocument/2006/relationships/image" Target="../media/image97.jpeg"/><Relationship Id="rId16" Type="http://schemas.openxmlformats.org/officeDocument/2006/relationships/image" Target="../media/image110.jpeg"/><Relationship Id="rId20" Type="http://schemas.openxmlformats.org/officeDocument/2006/relationships/image" Target="../media/image113.jpeg"/><Relationship Id="rId29" Type="http://schemas.openxmlformats.org/officeDocument/2006/relationships/image" Target="../media/image12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0.jpeg"/><Relationship Id="rId11" Type="http://schemas.openxmlformats.org/officeDocument/2006/relationships/image" Target="../media/image105.jpeg"/><Relationship Id="rId24" Type="http://schemas.openxmlformats.org/officeDocument/2006/relationships/image" Target="../media/image116.jpeg"/><Relationship Id="rId5" Type="http://schemas.openxmlformats.org/officeDocument/2006/relationships/image" Target="../media/image99.jpeg"/><Relationship Id="rId15" Type="http://schemas.openxmlformats.org/officeDocument/2006/relationships/image" Target="../media/image109.jpeg"/><Relationship Id="rId23" Type="http://schemas.openxmlformats.org/officeDocument/2006/relationships/image" Target="../media/image115.jpeg"/><Relationship Id="rId28" Type="http://schemas.microsoft.com/office/2007/relationships/hdphoto" Target="../media/hdphoto26.wdp"/><Relationship Id="rId10" Type="http://schemas.openxmlformats.org/officeDocument/2006/relationships/image" Target="../media/image104.jpeg"/><Relationship Id="rId19" Type="http://schemas.openxmlformats.org/officeDocument/2006/relationships/image" Target="../media/image112.jpeg"/><Relationship Id="rId4" Type="http://schemas.openxmlformats.org/officeDocument/2006/relationships/image" Target="../media/image98.jpeg"/><Relationship Id="rId9" Type="http://schemas.openxmlformats.org/officeDocument/2006/relationships/image" Target="../media/image103.jpeg"/><Relationship Id="rId14" Type="http://schemas.openxmlformats.org/officeDocument/2006/relationships/image" Target="../media/image108.jpeg"/><Relationship Id="rId22" Type="http://schemas.openxmlformats.org/officeDocument/2006/relationships/image" Target="../media/image114.jpeg"/><Relationship Id="rId27" Type="http://schemas.openxmlformats.org/officeDocument/2006/relationships/image" Target="../media/image119.jpeg"/><Relationship Id="rId30" Type="http://schemas.microsoft.com/office/2007/relationships/hdphoto" Target="../media/hdphoto27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7.jpeg"/><Relationship Id="rId13" Type="http://schemas.openxmlformats.org/officeDocument/2006/relationships/image" Target="../media/image132.jpeg"/><Relationship Id="rId18" Type="http://schemas.openxmlformats.org/officeDocument/2006/relationships/image" Target="../media/image137.jpeg"/><Relationship Id="rId3" Type="http://schemas.openxmlformats.org/officeDocument/2006/relationships/image" Target="../media/image122.jpeg"/><Relationship Id="rId21" Type="http://schemas.openxmlformats.org/officeDocument/2006/relationships/image" Target="../media/image140.jpeg"/><Relationship Id="rId7" Type="http://schemas.openxmlformats.org/officeDocument/2006/relationships/image" Target="../media/image126.jpeg"/><Relationship Id="rId12" Type="http://schemas.openxmlformats.org/officeDocument/2006/relationships/image" Target="../media/image131.jpeg"/><Relationship Id="rId17" Type="http://schemas.openxmlformats.org/officeDocument/2006/relationships/image" Target="../media/image136.jpeg"/><Relationship Id="rId25" Type="http://schemas.openxmlformats.org/officeDocument/2006/relationships/image" Target="../media/image144.jpeg"/><Relationship Id="rId2" Type="http://schemas.openxmlformats.org/officeDocument/2006/relationships/image" Target="../media/image121.jpeg"/><Relationship Id="rId16" Type="http://schemas.openxmlformats.org/officeDocument/2006/relationships/image" Target="../media/image135.jpeg"/><Relationship Id="rId20" Type="http://schemas.openxmlformats.org/officeDocument/2006/relationships/image" Target="../media/image13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5.jpeg"/><Relationship Id="rId11" Type="http://schemas.openxmlformats.org/officeDocument/2006/relationships/image" Target="../media/image130.jpeg"/><Relationship Id="rId24" Type="http://schemas.openxmlformats.org/officeDocument/2006/relationships/image" Target="../media/image143.jpeg"/><Relationship Id="rId5" Type="http://schemas.openxmlformats.org/officeDocument/2006/relationships/image" Target="../media/image124.jpeg"/><Relationship Id="rId15" Type="http://schemas.openxmlformats.org/officeDocument/2006/relationships/image" Target="../media/image134.jpeg"/><Relationship Id="rId23" Type="http://schemas.openxmlformats.org/officeDocument/2006/relationships/image" Target="../media/image142.jpeg"/><Relationship Id="rId10" Type="http://schemas.openxmlformats.org/officeDocument/2006/relationships/image" Target="../media/image129.jpeg"/><Relationship Id="rId19" Type="http://schemas.openxmlformats.org/officeDocument/2006/relationships/image" Target="../media/image138.jpeg"/><Relationship Id="rId4" Type="http://schemas.openxmlformats.org/officeDocument/2006/relationships/image" Target="../media/image123.jpeg"/><Relationship Id="rId9" Type="http://schemas.openxmlformats.org/officeDocument/2006/relationships/image" Target="../media/image128.jpeg"/><Relationship Id="rId14" Type="http://schemas.openxmlformats.org/officeDocument/2006/relationships/image" Target="../media/image133.jpeg"/><Relationship Id="rId22" Type="http://schemas.openxmlformats.org/officeDocument/2006/relationships/image" Target="../media/image141.jpe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826194" y="2442913"/>
            <a:ext cx="1242648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</a:p>
          <a:p>
            <a:pPr algn="ctr"/>
            <a:r>
              <a:rPr lang="en-US" altLang="ko-KR" sz="2800" dirty="0" smtClean="0">
                <a:solidFill>
                  <a:srgbClr val="00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pPr algn="ctr"/>
            <a:r>
              <a:rPr lang="en-US" altLang="ko-KR" sz="28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endParaRPr lang="ko-KR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3755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hahahamj\Desktop\새 폴더 (2)\U2OS rH2AX,P-ID3-NU사진\U2OS-NU-rH2AXP-ID3-0hr-5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594" y="8451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hahahamj\Desktop\새 폴더 (2)\U2OS rH2AX,P-ID3-NU사진\U2OS-NU-rH2AXP-ID3-0hr-5_c1+2+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594" y="54114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hahahamj\Desktop\새 폴더 (2)\U2OS rH2AX,P-ID3-NU사진\U2OS-NU-rH2AXP-ID3-0hr-5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727" y="23765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C:\Users\hahahamj\Desktop\새 폴더 (2)\U2OS rH2AX,P-ID3-NU사진\U2OS-NU-rH2AXP-ID3-0hr-5_c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727" y="389225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C:\Users\hahahamj\Desktop\새 폴더 (2)\U2OS rH2AX,P-ID3-NU사진\U2OS-NU-rH2AXP-ID3-0hr-6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762" y="8621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C:\Users\hahahamj\Desktop\새 폴더 (2)\U2OS rH2AX,P-ID3-NU사진\U2OS-NU-rH2AXP-ID3-0hr-6_c1+2+3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762" y="540805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C:\Users\hahahamj\Desktop\새 폴더 (2)\U2OS rH2AX,P-ID3-NU사진\U2OS-NU-rH2AXP-ID3-0hr-6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762" y="23765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5" name="Picture 9" descr="C:\Users\hahahamj\Desktop\새 폴더 (2)\U2OS rH2AX,P-ID3-NU사진\U2OS-NU-rH2AXP-ID3-0hr-6_c3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762" y="389225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6" name="Picture 10" descr="C:\Users\hahahamj\Desktop\새 폴더 (2)\U2OS rH2AX,P-ID3-NU사진\U2OS-NU-rH2AXP-ID3-0hr-1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7770" y="8621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7" name="Picture 11" descr="C:\Users\hahahamj\Desktop\새 폴더 (2)\U2OS rH2AX,P-ID3-NU사진\U2OS-NU-rH2AXP-ID3-0hr-1_c1+2+3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7770" y="540805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8" name="Picture 12" descr="C:\Users\hahahamj\Desktop\새 폴더 (2)\U2OS rH2AX,P-ID3-NU사진\U2OS-NU-rH2AXP-ID3-0hr-1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6369" y="23765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9" name="Picture 13" descr="C:\Users\hahahamj\Desktop\새 폴더 (2)\U2OS rH2AX,P-ID3-NU사진\U2OS-NU-rH2AXP-ID3-0hr-1_c3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7770" y="389225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0" name="Picture 14" descr="C:\Users\hahahamj\Desktop\새 폴더 (2)\U2OS rH2AX,P-ID3-NU사진\U2OS-NU-rH2AXP-ID3-0hr-2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2164" y="8621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1" name="Picture 15" descr="C:\Users\hahahamj\Desktop\새 폴더 (2)\U2OS rH2AX,P-ID3-NU사진\U2OS-NU-rH2AXP-ID3-0hr-2_c1+2+3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0130" y="538169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2" name="Picture 16" descr="C:\Users\hahahamj\Desktop\새 폴더 (2)\U2OS rH2AX,P-ID3-NU사진\U2OS-NU-rH2AXP-ID3-0hr-2_c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9938" y="23765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3" name="Picture 17" descr="C:\Users\hahahamj\Desktop\새 폴더 (2)\U2OS rH2AX,P-ID3-NU사진\U2OS-NU-rH2AXP-ID3-0hr-2_c3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9938" y="386952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4" name="Picture 18" descr="C:\Users\hahahamj\Desktop\새 폴더 (2)\U2OS rH2AX,P-ID3-NU사진\U2OS-NU-rH2AXP-ID3-0hr-3_c1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2106" y="87038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5" name="Picture 19" descr="C:\Users\hahahamj\Desktop\새 폴더 (2)\U2OS rH2AX,P-ID3-NU사진\U2OS-NU-rH2AXP-ID3-0hr-3_c1+2+3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1942" y="538169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6" name="Picture 20" descr="C:\Users\hahahamj\Desktop\새 폴더 (2)\U2OS rH2AX,P-ID3-NU사진\U2OS-NU-rH2AXP-ID3-0hr-3_c2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2106" y="23765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7" name="Picture 21" descr="C:\Users\hahahamj\Desktop\새 폴더 (2)\U2OS rH2AX,P-ID3-NU사진\U2OS-NU-rH2AXP-ID3-0hr-3_c3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2106" y="386952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8" name="Picture 22" descr="C:\Users\hahahamj\Desktop\새 폴더 (2)\U2OS rH2AX,P-ID3-NU사진\U2OS-NU-rH2AXP-ID3-0hr-4_c1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4274" y="8643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9" name="Picture 23" descr="C:\Users\hahahamj\Desktop\새 폴더 (2)\U2OS rH2AX,P-ID3-NU사진\U2OS-NU-rH2AXP-ID3-0hr-4_c1+2+3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4274" y="538169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20" name="Picture 24" descr="C:\Users\hahahamj\Desktop\새 폴더 (2)\U2OS rH2AX,P-ID3-NU사진\U2OS-NU-rH2AXP-ID3-0hr-4_c2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4274" y="235735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21" name="Picture 25" descr="C:\Users\hahahamj\Desktop\새 폴더 (2)\U2OS rH2AX,P-ID3-NU사진\U2OS-NU-rH2AXP-ID3-0hr-4_c3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4274" y="386952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7214" y="237292"/>
            <a:ext cx="48718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0hr(UT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3209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hahahamj\Desktop\새 폴더 (2)\U2OS rH2AX,P-ID3-NU사진\U2OS-NU-rH2AXP-ID3-3hr-1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23634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C:\Users\hahahamj\Desktop\새 폴더 (2)\U2OS rH2AX,P-ID3-NU사진\U2OS-NU-rH2AXP-ID3-3hr-1_c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8217" y="38636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C:\Users\hahahamj\Desktop\새 폴더 (2)\U2OS rH2AX,P-ID3-NU사진\U2OS-NU-rH2AXP-ID3-3hr-2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56" y="83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hahahamj\Desktop\새 폴더 (2)\U2OS rH2AX,P-ID3-NU사진\U2OS-NU-rH2AXP-ID3-3hr-2_c1+2+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90" y="53733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6" name="Picture 6" descr="C:\Users\hahahamj\Desktop\새 폴더 (2)\U2OS rH2AX,P-ID3-NU사진\U2OS-NU-rH2AXP-ID3-3hr-2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56" y="236792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7" name="Picture 7" descr="C:\Users\hahahamj\Desktop\새 폴더 (2)\U2OS rH2AX,P-ID3-NU사진\U2OS-NU-rH2AXP-ID3-3hr-2_c3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90" y="38392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8" name="Picture 8" descr="C:\Users\hahahamj\Desktop\새 폴더 (2)\U2OS rH2AX,P-ID3-NU사진\U2OS-NU-rH2AXP-ID3-3hr-3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9639" y="83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9" name="Picture 9" descr="C:\Users\hahahamj\Desktop\새 폴더 (2)\U2OS rH2AX,P-ID3-NU사진\U2OS-NU-rH2AXP-ID3-3hr-3_c1+2+3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6031" y="53733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0" name="Picture 10" descr="C:\Users\hahahamj\Desktop\새 폴더 (2)\U2OS rH2AX,P-ID3-NU사진\U2OS-NU-rH2AXP-ID3-3hr-3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6031" y="236792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1" name="Picture 11" descr="C:\Users\hahahamj\Desktop\새 폴더 (2)\U2OS rH2AX,P-ID3-NU사진\U2OS-NU-rH2AXP-ID3-3hr-3_c3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7964" y="38636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2" name="Picture 12" descr="C:\Users\hahahamj\Desktop\새 폴더 (2)\U2OS rH2AX,P-ID3-NU사진\U2OS-NU-rH2AXP-ID3-3hr-4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1713" y="83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3" name="Picture 13" descr="C:\Users\hahahamj\Desktop\새 폴더 (2)\U2OS rH2AX,P-ID3-NU사진\U2OS-NU-rH2AXP-ID3-3hr-4_c1+2+3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1713" y="53733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4" name="Picture 14" descr="C:\Users\hahahamj\Desktop\새 폴더 (2)\U2OS rH2AX,P-ID3-NU사진\U2OS-NU-rH2AXP-ID3-3hr-4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1713" y="236792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5" name="Picture 15" descr="C:\Users\hahahamj\Desktop\새 폴더 (2)\U2OS rH2AX,P-ID3-NU사진\U2OS-NU-rH2AXP-ID3-3hr-4_c3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1713" y="386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6" name="Picture 16" descr="C:\Users\hahahamj\Desktop\새 폴더 (2)\U2OS rH2AX,P-ID3-NU사진\U2OS-NU-rH2AXP-ID3-3hr-5_c1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3881" y="83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7" name="Picture 17" descr="C:\Users\hahahamj\Desktop\새 폴더 (2)\U2OS rH2AX,P-ID3-NU사진\U2OS-NU-rH2AXP-ID3-3hr-5_c1+2+3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3881" y="53733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8" name="Picture 18" descr="C:\Users\hahahamj\Desktop\새 폴더 (2)\U2OS rH2AX,P-ID3-NU사진\U2OS-NU-rH2AXP-ID3-3hr-5_c2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3881" y="236792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9" name="Picture 19" descr="C:\Users\hahahamj\Desktop\새 폴더 (2)\U2OS rH2AX,P-ID3-NU사진\U2OS-NU-rH2AXP-ID3-3hr-5_c3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3881" y="386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0" name="Picture 20" descr="C:\Users\hahahamj\Desktop\새 폴더 (2)\U2OS rH2AX,P-ID3-NU사진\U2OS-NU-rH2AXP-ID3-3hr-6_c1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6049" y="83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1" name="Picture 21" descr="C:\Users\hahahamj\Desktop\새 폴더 (2)\U2OS rH2AX,P-ID3-NU사진\U2OS-NU-rH2AXP-ID3-3hr-6_c1+2+3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6049" y="53733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2" name="Picture 22" descr="C:\Users\hahahamj\Desktop\새 폴더 (2)\U2OS rH2AX,P-ID3-NU사진\U2OS-NU-rH2AXP-ID3-3hr-6_c2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6049" y="234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3" name="Picture 23" descr="C:\Users\hahahamj\Desktop\새 폴더 (2)\U2OS rH2AX,P-ID3-NU사진\U2OS-NU-rH2AXP-ID3-3hr-6_c3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6049" y="386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4" name="Picture 24" descr="C:\Users\hahahamj\Desktop\새 폴더 (2)\U2OS rH2AX,P-ID3-NU사진\U2OS-NU-rH2AXP-ID3-3hr-1_c1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8368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5" name="Picture 25" descr="C:\Users\hahahamj\Desktop\새 폴더 (2)\U2OS rH2AX,P-ID3-NU사진\U2OS-NU-rH2AXP-ID3-3hr-1_c1+2+3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8217" y="53733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7214" y="237292"/>
            <a:ext cx="42562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1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3209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hahahamj\Desktop\새 폴더 (2)\U2OS rH2AX,P-ID3-NU사진\U2OS-NU-rH2AXP-ID3-6hr-3_c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3532" y="389614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C:\Users\hahahamj\Desktop\새 폴더 (2)\U2OS rH2AX,P-ID3-NU사진\U2OS-NU-rH2AXP-ID3-6hr-4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184" y="87181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C:\Users\hahahamj\Desktop\새 폴더 (2)\U2OS rH2AX,P-ID3-NU사진\U2OS-NU-rH2AXP-ID3-6hr-4_c1+2+3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184" y="541385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C:\Users\hahahamj\Desktop\새 폴더 (2)\U2OS rH2AX,P-ID3-NU사진\U2OS-NU-rH2AXP-ID3-6hr-4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184" y="240749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C:\Users\hahahamj\Desktop\새 폴더 (2)\U2OS rH2AX,P-ID3-NU사진\U2OS-NU-rH2AXP-ID3-6hr-4_c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184" y="389614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1" name="Picture 7" descr="C:\Users\hahahamj\Desktop\새 폴더 (2)\U2OS rH2AX,P-ID3-NU사진\U2OS-NU-rH2AXP-ID3-6hr-5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9192" y="87181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2" name="Picture 8" descr="C:\Users\hahahamj\Desktop\새 폴더 (2)\U2OS rH2AX,P-ID3-NU사진\U2OS-NU-rH2AXP-ID3-6hr-5_c1+2+3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131" y="540831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3" name="Picture 9" descr="C:\Users\hahahamj\Desktop\새 폴더 (2)\U2OS rH2AX,P-ID3-NU사진\U2OS-NU-rH2AXP-ID3-6hr-5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9192" y="240749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4" name="Picture 10" descr="C:\Users\hahahamj\Desktop\새 폴더 (2)\U2OS rH2AX,P-ID3-NU사진\U2OS-NU-rH2AXP-ID3-6hr-5_c3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9192" y="390819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5" name="Picture 11" descr="C:\Users\hahahamj\Desktop\새 폴더 (2)\U2OS rH2AX,P-ID3-NU사진\U2OS-NU-rH2AXP-ID3-6hr-6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7348" y="87181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6" name="Picture 12" descr="C:\Users\hahahamj\Desktop\새 폴더 (2)\U2OS rH2AX,P-ID3-NU사진\U2OS-NU-rH2AXP-ID3-6hr-6_c1+2+3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4325" y="540831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7" name="Picture 13" descr="C:\Users\hahahamj\Desktop\새 폴더 (2)\U2OS rH2AX,P-ID3-NU사진\U2OS-NU-rH2AXP-ID3-6hr-6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7348" y="239539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8" name="Picture 14" descr="C:\Users\hahahamj\Desktop\새 폴더 (2)\U2OS rH2AX,P-ID3-NU사진\U2OS-NU-rH2AXP-ID3-6hr-6_c3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4325" y="391447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9" name="Picture 15" descr="C:\Users\hahahamj\Desktop\새 폴더 (2)\U2OS rH2AX,P-ID3-NU사진\U2OS-NU-rH2AXP-ID3-6hr-1_c1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9356" y="87181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0" name="Picture 16" descr="C:\Users\hahahamj\Desktop\새 폴더 (2)\U2OS rH2AX,P-ID3-NU사진\U2OS-NU-rH2AXP-ID3-6hr-1_c1+2+3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9356" y="541385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1" name="Picture 17" descr="C:\Users\hahahamj\Desktop\새 폴더 (2)\U2OS rH2AX,P-ID3-NU사진\U2OS-NU-rH2AXP-ID3-6hr-1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9356" y="240445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2" name="Picture 18" descr="C:\Users\hahahamj\Desktop\새 폴더 (2)\U2OS rH2AX,P-ID3-NU사진\U2OS-NU-rH2AXP-ID3-6hr-1_c3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9356" y="391447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3" name="Picture 19" descr="C:\Users\hahahamj\Desktop\새 폴더 (2)\U2OS rH2AX,P-ID3-NU사진\U2OS-NU-rH2AXP-ID3-6hr-2_c1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1364" y="87181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4" name="Picture 20" descr="C:\Users\hahahamj\Desktop\새 폴더 (2)\U2OS rH2AX,P-ID3-NU사진\U2OS-NU-rH2AXP-ID3-6hr-2_c1+2+3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1364" y="541385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5" name="Picture 21" descr="C:\Users\hahahamj\Desktop\새 폴더 (2)\U2OS rH2AX,P-ID3-NU사진\U2OS-NU-rH2AXP-ID3-6hr-2_c2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1364" y="240445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6" name="Picture 22" descr="C:\Users\hahahamj\Desktop\새 폴더 (2)\U2OS rH2AX,P-ID3-NU사진\U2OS-NU-rH2AXP-ID3-6hr-2_c3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1364" y="390819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7" name="Picture 23" descr="C:\Users\hahahamj\Desktop\새 폴더 (2)\U2OS rH2AX,P-ID3-NU사진\U2OS-NU-rH2AXP-ID3-6hr-3_c1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84356" y="87181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8" name="Picture 24" descr="C:\Users\hahahamj\Desktop\새 폴더 (2)\U2OS rH2AX,P-ID3-NU사진\U2OS-NU-rH2AXP-ID3-6hr-3_c1+2+3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84356" y="541385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69" name="Picture 25" descr="C:\Users\hahahamj\Desktop\새 폴더 (2)\U2OS rH2AX,P-ID3-NU사진\U2OS-NU-rH2AXP-ID3-6hr-3_c2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84356" y="240445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7214" y="237292"/>
            <a:ext cx="42936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3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32097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8" descr="C:\Users\chosun\Desktop\progress report\17.02.28 progress report\17.02.28 U2OS P-ID3 early time\U2OS10Gy-UT-P-ID3-crop2-Image Export-27_c1+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4771" y="413021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9" descr="C:\Users\chosun\Desktop\progress report\17.02.28 progress report\17.02.28 U2OS P-ID3 early time\U2OS10Gy-UT-P-ID3-crop2-Image Export-27_c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4771" y="278092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2998590" y="1238073"/>
            <a:ext cx="1657550" cy="2892146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pic>
        <p:nvPicPr>
          <p:cNvPr id="7" name="Picture 7" descr="C:\Users\chosun\Desktop\progress report\17.02.28 progress report\17.02.28 U2OS P-ID3 early time\U2OS10Gy-UT-P-ID3-crop2-Image Export-27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4771" y="141605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982549" y="537097"/>
            <a:ext cx="214353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 –DMSO –</a:t>
            </a:r>
            <a:r>
              <a:rPr lang="en-US" altLang="ko-KR" sz="1662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D3</a:t>
            </a:r>
            <a:endParaRPr lang="ko-KR" altLang="en-US" sz="1662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358813" y="537096"/>
            <a:ext cx="46839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4" descr="C:\Users\chosun\Desktop\progress report\17.02.28 progress report\17.02.28 U2OS P-ID3 early time\U2OS10Gy-UT-P-ID3-crop1-Image Export-26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6016" y="141605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5" descr="C:\Users\chosun\Desktop\progress report\17.02.28 progress report\17.02.28 U2OS P-ID3 early time\U2OS10Gy-UT-P-ID3-crop1-Image Export-26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6016" y="413021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6" descr="C:\Users\chosun\Desktop\progress report\17.02.28 progress report\17.02.28 U2OS P-ID3 early time\U2OS10Gy-UT-P-ID3-crop1-Image Export-26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6016" y="278092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615018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959059" y="684758"/>
            <a:ext cx="214353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 –DMSO –</a:t>
            </a:r>
            <a:r>
              <a:rPr lang="en-US" altLang="ko-KR" sz="1662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D3</a:t>
            </a:r>
            <a:endParaRPr lang="ko-KR" altLang="en-US" sz="1662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24" descr="C:\Users\chosun\Desktop\progress report\17.02.28 progress report\17.02.28 U2OS P-ID3 early time\U2OSP-ID3-10Gy-180min-crop5-Image Export-56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8121" y="166890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25" descr="C:\Users\chosun\Desktop\progress report\17.02.28 progress report\17.02.28 U2OS P-ID3 early time\U2OSP-ID3-10Gy-180min-crop5-Image Export-56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7115" y="446060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26" descr="C:\Users\chosun\Desktop\progress report\17.02.28 progress report\17.02.28 U2OS P-ID3 early time\U2OSP-ID3-10Gy-180min-crop5-Image Export-56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1455" y="306490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직사각형 20"/>
          <p:cNvSpPr/>
          <p:nvPr/>
        </p:nvSpPr>
        <p:spPr>
          <a:xfrm>
            <a:off x="1115616" y="1493589"/>
            <a:ext cx="1718847" cy="296701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2" name="TextBox 1"/>
          <p:cNvSpPr txBox="1"/>
          <p:nvPr/>
        </p:nvSpPr>
        <p:spPr>
          <a:xfrm>
            <a:off x="4338762" y="684758"/>
            <a:ext cx="104547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30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15" descr="C:\Users\chosun\Desktop\progress report\17.02.28 progress report\17.02.28 U2OS P-ID3 early time\U2OSP-ID3-10Gy-40min-crop1-Image Export-35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0827" y="166890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6" descr="C:\Users\chosun\Desktop\progress report\17.02.28 progress report\17.02.28 U2OS P-ID3 early time\U2OSP-ID3-10Gy-40min-crop1-Image Export-35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9531" y="446060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7" descr="C:\Users\chosun\Desktop\progress report\17.02.28 progress report\17.02.28 U2OS P-ID3 early time\U2OSP-ID3-10Gy-40min-crop1-Image Export-35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0827" y="306490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2" descr="C:\Users\chosun\Desktop\progress report\17.02.15 progress report\siID3-MDC1,P-ID3\U2OSsiID3-2Gy-30min_MDC1-crop2-Image Export-40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5238" y="166890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13" descr="C:\Users\chosun\Desktop\progress report\17.02.15 progress report\siID3-MDC1,P-ID3\U2OSsiID3-2Gy-30min_MDC1-crop2-Image Export-40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5238" y="446060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14" descr="C:\Users\chosun\Desktop\progress report\17.02.15 progress report\siID3-MDC1,P-ID3\U2OSsiID3-2Gy-30min_MDC1-crop2-Image Export-40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2646" y="306490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15" descr="C:\Users\chosun\Desktop\progress report\17.02.15 progress report\siID3-MDC1,P-ID3\U2OSsiID3-2Gy-30min_MDC1-crop3-Image Export-41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6799" y="166890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6" descr="C:\Users\chosun\Desktop\progress report\17.02.15 progress report\siID3-MDC1,P-ID3\U2OSsiID3-2Gy-30min_MDC1-crop3-Image Export-41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4264" y="446060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7" descr="C:\Users\chosun\Desktop\progress report\17.02.15 progress report\siID3-MDC1,P-ID3\U2OSsiID3-2Gy-30min_MDC1-crop3-Image Export-41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4264" y="306490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41998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483768" y="603902"/>
            <a:ext cx="214353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 –DMSO –</a:t>
            </a:r>
            <a:r>
              <a:rPr lang="en-US" altLang="ko-KR" sz="1662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D3</a:t>
            </a:r>
            <a:endParaRPr lang="ko-KR" altLang="en-US" sz="1662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21" descr="C:\Users\chosun\Desktop\progress report\17.02.28 progress report\17.02.28 U2OS P-ID3 early time\U2OSP-ID3-10Gy-180min-crop4-Image Export-55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3140" y="13899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22" descr="C:\Users\chosun\Desktop\progress report\17.02.28 progress report\17.02.28 U2OS P-ID3 early time\U2OSP-ID3-10Gy-180min-crop4-Image Export-55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8186" y="416222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23" descr="C:\Users\chosun\Desktop\progress report\17.02.28 progress report\17.02.28 U2OS P-ID3 early time\U2OSP-ID3-10Gy-180min-crop4-Image Export-55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3140" y="276782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4906649" y="632619"/>
            <a:ext cx="68800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1h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7" descr="C:\Users\chosun\Desktop\progress report\17.02.15 progress report\siID3-MDC1,P-ID3\U2OSsiCTL-2Gy-30min_MDC1-crop4-Image Export-18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1360" y="13899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8" descr="C:\Users\chosun\Desktop\progress report\17.02.15 progress report\siID3-MDC1,P-ID3\U2OSsiCTL-2Gy-30min_MDC1-crop4-Image Export-18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1360" y="416222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9" descr="C:\Users\chosun\Desktop\progress report\17.02.15 progress report\siID3-MDC1,P-ID3\U2OSsiCTL-2Gy-30min_MDC1-crop4-Image Export-18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1360" y="276782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6" descr="C:\Users\chosun\Desktop\progress report\17.02.15 progress report\siID3-MDC1,P-ID3\U2OSsiCTL-2Gy-30min_MDC1-crop1-Image Export-15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3698" y="13899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17" descr="C:\Users\chosun\Desktop\progress report\17.02.15 progress report\siID3-MDC1,P-ID3\U2OSsiCTL-2Gy-30min_MDC1-crop1-Image Export-15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3698" y="416222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18" descr="C:\Users\chosun\Desktop\progress report\17.02.15 progress report\siID3-MDC1,P-ID3\U2OSsiCTL-2Gy-30min_MDC1-crop1-Image Export-15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3698" y="276782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13" descr="C:\Users\chosun\Desktop\progress report\17.02.15 progress report\siID3-MDC1,P-ID3\U2OSsiCTL-2Gy-30min_P-ID3-crop4-Image Export-24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9066" y="13899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4" descr="C:\Users\chosun\Desktop\progress report\17.02.15 progress report\siID3-MDC1,P-ID3\U2OSsiCTL-2Gy-30min_P-ID3-crop4-Image Export-24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9066" y="416222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5" descr="C:\Users\chosun\Desktop\progress report\17.02.15 progress report\siID3-MDC1,P-ID3\U2OSsiCTL-2Gy-30min_P-ID3-crop4-Image Export-24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9066" y="276782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직사각형 12"/>
          <p:cNvSpPr/>
          <p:nvPr/>
        </p:nvSpPr>
        <p:spPr>
          <a:xfrm>
            <a:off x="2410403" y="1325127"/>
            <a:ext cx="1501000" cy="282829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</p:spTree>
    <p:extLst>
      <p:ext uri="{BB962C8B-B14F-4D97-AF65-F5344CB8AC3E}">
        <p14:creationId xmlns:p14="http://schemas.microsoft.com/office/powerpoint/2010/main" val="156482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867710" y="556946"/>
            <a:ext cx="214353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 –DMSO –</a:t>
            </a:r>
            <a:r>
              <a:rPr lang="en-US" altLang="ko-KR" sz="1662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D3</a:t>
            </a:r>
            <a:endParaRPr lang="ko-KR" altLang="en-US" sz="1662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18" descr="C:\Users\chosun\Desktop\progress report\17.02.28 progress report\17.02.28 U2OS P-ID3 early time\U2OSP-ID3-10Gy-180min-crop3-Image Export-54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4625" y="144856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9" descr="C:\Users\chosun\Desktop\progress report\17.02.28 progress report\17.02.28 U2OS P-ID3 early time\U2OSP-ID3-10Gy-180min-crop3-Image Export-54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7657" y="424835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0" descr="C:\Users\chosun\Desktop\progress report\17.02.28 progress report\17.02.28 U2OS P-ID3 early time\U2OSP-ID3-10Gy-180min-crop3-Image Export-54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3433" y="285951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직사각형 16"/>
          <p:cNvSpPr/>
          <p:nvPr/>
        </p:nvSpPr>
        <p:spPr>
          <a:xfrm>
            <a:off x="1403647" y="1351925"/>
            <a:ext cx="1461319" cy="283682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22" name="TextBox 21"/>
          <p:cNvSpPr txBox="1"/>
          <p:nvPr/>
        </p:nvSpPr>
        <p:spPr>
          <a:xfrm>
            <a:off x="5148064" y="560611"/>
            <a:ext cx="68800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3h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18" descr="C:\Users\chosun\Desktop\progress report\17.02.28 progress report\17.02.28 U2OS P-ID3 early time\U2OSP-ID3-10Gy-40min-crop2-Image Export-36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5027" y="144856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9" descr="C:\Users\chosun\Desktop\progress report\17.02.28 progress report\17.02.28 U2OS P-ID3 early time\U2OSP-ID3-10Gy-40min-crop2-Image Export-36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5027" y="424835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0" descr="C:\Users\chosun\Desktop\progress report\17.02.28 progress report\17.02.28 U2OS P-ID3 early time\U2OSP-ID3-10Gy-40min-crop2-Image Export-36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5027" y="285951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2" descr="C:\Users\chosun\Desktop\progress report\17.02.15 progress report\siID3-MDC1,P-ID3\U2OSsiID3-2Gy-30min_MDC1-crop4-Image Export-42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37195" y="285951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9" descr="C:\Users\chosun\Desktop\progress report\17.02.15 progress report\siID3-MDC1,P-ID3\U2OSsiID3-2Gy-30min_MDC1-crop1-Image Export-39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7377" y="144856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10" descr="C:\Users\chosun\Desktop\progress report\17.02.15 progress report\siID3-MDC1,P-ID3\U2OSsiID3-2Gy-30min_MDC1-crop1-Image Export-39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7377" y="424835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1" descr="C:\Users\chosun\Desktop\progress report\17.02.15 progress report\siID3-MDC1,P-ID3\U2OSsiID3-2Gy-30min_MDC1-crop1-Image Export-39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7377" y="285951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8" descr="C:\Users\chosun\Desktop\progress report\17.02.15 progress report\siID3-MDC1,P-ID3\U2OSsiID3-2Gy-30min_MDC1-crop4-Image Export-42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37195" y="144856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19" descr="C:\Users\chosun\Desktop\progress report\17.02.15 progress report\siID3-MDC1,P-ID3\U2OSsiID3-2Gy-30min_MDC1-crop4-Image Export-42_c1+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37195" y="424835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56735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793052"/>
            <a:ext cx="172675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 –Ku55933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16" descr="C:\Users\chosun\Desktop\progress report\17.02.28 progress report\17.02.28 U2OS P-ID3 early time\U2OS10Gy-UT-P-ID3-crop5-Image Export-30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3514" y="169841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17" descr="C:\Users\chosun\Desktop\progress report\17.02.28 progress report\17.02.28 U2OS P-ID3 early time\U2OS10Gy-UT-P-ID3-crop5-Image Export-30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6141" y="449025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18" descr="C:\Users\chosun\Desktop\progress report\17.02.28 progress report\17.02.28 U2OS P-ID3 early time\U2OS10Gy-UT-P-ID3-crop5-Image Export-30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3514" y="309425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881436" y="1556792"/>
            <a:ext cx="1844140" cy="289458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  <p:sp>
        <p:nvSpPr>
          <p:cNvPr id="20" name="TextBox 19"/>
          <p:cNvSpPr txBox="1"/>
          <p:nvPr/>
        </p:nvSpPr>
        <p:spPr>
          <a:xfrm>
            <a:off x="2519953" y="752891"/>
            <a:ext cx="46839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764019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18815" y="641633"/>
            <a:ext cx="172675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 –Ku55933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20" descr="C:\Users\chosun\Desktop\progress report\17.02.28 progress report\17.02.28 U2OS P-ID3 early time\U2OS10Gy-20min-P-ID3-crop5-Image Export-22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1991" y="138058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21" descr="C:\Users\chosun\Desktop\progress report\17.02.28 progress report\17.02.28 U2OS P-ID3 early time\U2OS10Gy-20min-P-ID3-crop5-Image Export-22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1991" y="428207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22" descr="C:\Users\chosun\Desktop\progress report\17.02.28 progress report\17.02.28 U2OS P-ID3 early time\U2OS10Gy-20min-P-ID3-crop5-Image Export-22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1991" y="281226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4787797" y="641633"/>
            <a:ext cx="104547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30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6" descr="C:\Users\chosun\Desktop\progress report\17.02.28 progress report\17.02.28 U2OS P-ID3 early time\U2OS10Gy-0min-P-ID3-crop1-Image Export-02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9585" y="138058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7" descr="C:\Users\chosun\Desktop\progress report\17.02.28 progress report\17.02.28 U2OS P-ID3 early time\U2OS10Gy-0min-P-ID3-crop1-Image Export-02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6915" y="428207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8" descr="C:\Users\chosun\Desktop\progress report\17.02.28 progress report\17.02.28 U2OS P-ID3 early time\U2OS10Gy-0min-P-ID3-crop1-Image Export-02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9585" y="281226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1" descr="C:\Users\chosun\Desktop\progress report\17.02.15 progress report\siID3-MDC1,P-ID3\U2OSsiID3-2Gy-15min_P-ID3-crop2-Image Export-34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0431" y="138058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12" descr="C:\Users\chosun\Desktop\progress report\17.02.15 progress report\siID3-MDC1,P-ID3\U2OSsiID3-2Gy-15min_P-ID3-crop2-Image Export-34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4476" y="428207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13" descr="C:\Users\chosun\Desktop\progress report\17.02.15 progress report\siID3-MDC1,P-ID3\U2OSsiID3-2Gy-15min_P-ID3-crop2-Image Export-34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4476" y="281226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14" descr="C:\Users\chosun\Desktop\progress report\17.02.15 progress report\siID3-MDC1,P-ID3\U2OSsiID3-2Gy-15min_P-ID3-crop3-Image Export-35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584" y="138058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5" descr="C:\Users\chosun\Desktop\progress report\17.02.15 progress report\siID3-MDC1,P-ID3\U2OSsiID3-2Gy-15min_P-ID3-crop3-Image Export-35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584" y="428207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6" descr="C:\Users\chosun\Desktop\progress report\17.02.15 progress report\siID3-MDC1,P-ID3\U2OSsiID3-2Gy-15min_P-ID3-crop3-Image Export-35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584" y="281226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직사각형 12"/>
          <p:cNvSpPr/>
          <p:nvPr/>
        </p:nvSpPr>
        <p:spPr>
          <a:xfrm>
            <a:off x="5904368" y="1264389"/>
            <a:ext cx="1547952" cy="2956699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251690010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18815" y="641633"/>
            <a:ext cx="172675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 –Ku55933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17" descr="C:\Users\chosun\Desktop\progress report\17.02.28 progress report\17.02.28 U2OS P-ID3 early time\U2OSP-ID3-10Gy-60min-crop6-Image Export-47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4534" y="155728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8" descr="C:\Users\chosun\Desktop\progress report\17.02.28 progress report\17.02.28 U2OS P-ID3 early time\U2OSP-ID3-10Gy-60min-crop6-Image Export-47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4534" y="431183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9" descr="C:\Users\chosun\Desktop\progress report\17.02.28 progress report\17.02.28 U2OS P-ID3 early time\U2OSP-ID3-10Gy-60min-crop6-Image Export-47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4534" y="291844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4932040" y="641632"/>
            <a:ext cx="68800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1h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10" descr="C:\Users\chosun\Desktop\progress report\17.02.28 progress report\17.02.28 U2OS P-ID3 early time\U2OS10Gy-10min-P-ID3-crop2-Image Export-11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55728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1" descr="C:\Users\chosun\Desktop\progress report\17.02.28 progress report\17.02.28 U2OS P-ID3 early time\U2OS10Gy-10min-P-ID3-crop2-Image Export-11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431183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2" descr="C:\Users\chosun\Desktop\progress report\17.02.28 progress report\17.02.28 U2OS P-ID3 early time\U2OS10Gy-10min-P-ID3-crop2-Image Export-11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91844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3" descr="C:\Users\chosun\Desktop\progress report\17.02.28 progress report\17.02.28 U2OS P-ID3 early time\U2OS10Gy-10min-P-ID3-crop3-Image Export-12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4826" y="155728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14" descr="C:\Users\chosun\Desktop\progress report\17.02.28 progress report\17.02.28 U2OS P-ID3 early time\U2OS10Gy-10min-P-ID3-crop3-Image Export-12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4826" y="431183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15" descr="C:\Users\chosun\Desktop\progress report\17.02.28 progress report\17.02.28 U2OS P-ID3 early time\U2OS10Gy-10min-P-ID3-crop3-Image Export-12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6979" y="291844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3" descr="C:\Users\chosun\Desktop\progress report\17.02.28 progress report\17.02.28 U2OS P-ID3 early time\U2OSP-ID3-10Gy-40min-crop6-Image Export-40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5544" y="155728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4" descr="C:\Users\chosun\Desktop\progress report\17.02.28 progress report\17.02.28 U2OS P-ID3 early time\U2OSP-ID3-10Gy-40min-crop6-Image Export-40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87021" y="431183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5" descr="C:\Users\chosun\Desktop\progress report\17.02.28 progress report\17.02.28 U2OS P-ID3 early time\U2OSP-ID3-10Gy-40min-crop6-Image Export-40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87021" y="291844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직사각형 16"/>
          <p:cNvSpPr/>
          <p:nvPr/>
        </p:nvSpPr>
        <p:spPr>
          <a:xfrm>
            <a:off x="1547664" y="1484784"/>
            <a:ext cx="1609315" cy="276289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2458642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hahahamj\Desktop\새 폴더 (2)\U2OS rH2AX,P-ID3\U2OS-rH2AXP-ID3-0hr-5_c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386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hahahamj\Desktop\새 폴더 (2)\U2OS rH2AX,P-ID3\U2OS-rH2AXP-ID3-0hr-6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6336" y="83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hahahamj\Desktop\새 폴더 (2)\U2OS rH2AX,P-ID3\U2OS-rH2AXP-ID3-0hr-6_c1+2+3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6336" y="53537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hahahamj\Desktop\새 폴더 (2)\U2OS rH2AX,P-ID3\U2OS-rH2AXP-ID3-0hr-6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6336" y="232845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hahahamj\Desktop\새 폴더 (2)\U2OS rH2AX,P-ID3\U2OS-rH2AXP-ID3-0hr-6_c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6336" y="38230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hahahamj\Desktop\새 폴더 (2)\U2OS rH2AX,P-ID3\U2OS-rH2AXP-ID3-0hr-1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328" y="83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hahahamj\Desktop\새 폴더 (2)\U2OS rH2AX,P-ID3\U2OS-rH2AXP-ID3-0hr-1_c1+2+3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328" y="53667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hahahamj\Desktop\새 폴더 (2)\U2OS rH2AX,P-ID3\U2OS-rH2AXP-ID3-0hr-1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328" y="232829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hahahamj\Desktop\새 폴더 (2)\U2OS rH2AX,P-ID3\U2OS-rH2AXP-ID3-0hr-1_c3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328" y="386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C:\Users\hahahamj\Desktop\새 폴더 (2)\U2OS rH2AX,P-ID3\U2OS-rH2AXP-ID3-0hr-2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7110" y="83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C:\Users\hahahamj\Desktop\새 폴더 (2)\U2OS rH2AX,P-ID3\U2OS-rH2AXP-ID3-0hr-2_c1+2+3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7110" y="53667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7" name="Picture 13" descr="C:\Users\hahahamj\Desktop\새 폴더 (2)\U2OS rH2AX,P-ID3\U2OS-rH2AXP-ID3-0hr-2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32829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C:\Users\hahahamj\Desktop\새 폴더 (2)\U2OS rH2AX,P-ID3\U2OS-rH2AXP-ID3-0hr-2_c3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386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9" name="Picture 15" descr="C:\Users\hahahamj\Desktop\새 폴더 (2)\U2OS rH2AX,P-ID3\U2OS-rH2AXP-ID3-0hr-3_c1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4945" y="83294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C:\Users\hahahamj\Desktop\새 폴더 (2)\U2OS rH2AX,P-ID3\U2OS-rH2AXP-ID3-0hr-3_c1+2+3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2801" y="53667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1" name="Picture 17" descr="C:\Users\hahahamj\Desktop\새 폴더 (2)\U2OS rH2AX,P-ID3\U2OS-rH2AXP-ID3-0hr-3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6318" y="386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C:\Users\hahahamj\Desktop\새 폴더 (2)\U2OS rH2AX,P-ID3\U2OS-rH2AXP-ID3-0hr-3_c3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7890" y="234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3" name="Picture 19" descr="C:\Users\hahahamj\Desktop\새 폴더 (2)\U2OS rH2AX,P-ID3\U2OS-rH2AXP-ID3-0hr-4_c1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0034" y="81612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C:\Users\hahahamj\Desktop\새 폴더 (2)\U2OS rH2AX,P-ID3\U2OS-rH2AXP-ID3-0hr-4_c1+2+3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7890" y="53667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5" name="Picture 21" descr="C:\Users\hahahamj\Desktop\새 폴더 (2)\U2OS rH2AX,P-ID3\U2OS-rH2AXP-ID3-0hr-4_c2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6318" y="234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6" name="Picture 22" descr="C:\Users\hahahamj\Desktop\새 폴더 (2)\U2OS rH2AX,P-ID3\U2OS-rH2AXP-ID3-0hr-4_c3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7890" y="386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7" name="Picture 23" descr="C:\Users\hahahamj\Desktop\새 폴더 (2)\U2OS rH2AX,P-ID3\U2OS-rH2AXP-ID3-0hr-5_c1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82" y="81612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8" name="Picture 24" descr="C:\Users\hahahamj\Desktop\새 폴더 (2)\U2OS rH2AX,P-ID3\U2OS-rH2AXP-ID3-0hr-5_c1+2+3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38" y="53667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9" name="Picture 25" descr="C:\Users\hahahamj\Desktop\새 폴더 (2)\U2OS rH2AX,P-ID3\U2OS-rH2AXP-ID3-0hr-5_c2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38" y="234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7214" y="237292"/>
            <a:ext cx="34467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UT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079276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18815" y="641633"/>
            <a:ext cx="172675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 –Ku55933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14" descr="C:\Users\chosun\Desktop\progress report\17.02.28 progress report\17.02.28 U2OS P-ID3 early time\U2OSP-ID3-10Gy-60min-crop5-Image Export-46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2791" y="144242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5" descr="C:\Users\chosun\Desktop\progress report\17.02.28 progress report\17.02.28 U2OS P-ID3 early time\U2OSP-ID3-10Gy-60min-crop5-Image Export-46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2791" y="423777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6" descr="C:\Users\chosun\Desktop\progress report\17.02.28 progress report\17.02.28 U2OS P-ID3 early time\U2OSP-ID3-10Gy-60min-crop5-Image Export-46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2791" y="283240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4874848" y="623916"/>
            <a:ext cx="68800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3h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11" descr="C:\Users\chosun\Desktop\progress report\17.02.28 progress report\17.02.28 U2OS P-ID3 early time\U2OS10Gy-20min-P-ID3-crop2-Image Export-19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268" y="144242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12" descr="C:\Users\chosun\Desktop\progress report\17.02.28 progress report\17.02.28 U2OS P-ID3 early time\U2OS10Gy-20min-P-ID3-crop2-Image Export-19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268" y="423777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3" descr="C:\Users\chosun\Desktop\progress report\17.02.28 progress report\17.02.28 U2OS P-ID3 early time\U2OS10Gy-20min-P-ID3-crop2-Image Export-19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268" y="283240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4" descr="C:\Users\chosun\Desktop\progress report\17.02.15 progress report\siID3-MDC1,P-ID3\U2OSsiCTL-2Gy-30min_P-ID3-crop1-Image Export-21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342" y="144242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5" descr="C:\Users\chosun\Desktop\progress report\17.02.15 progress report\siID3-MDC1,P-ID3\U2OSsiCTL-2Gy-30min_P-ID3-crop1-Image Export-21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342" y="423777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6" descr="C:\Users\chosun\Desktop\progress report\17.02.15 progress report\siID3-MDC1,P-ID3\U2OSsiCTL-2Gy-30min_P-ID3-crop1-Image Export-21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342" y="283240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7" descr="C:\Users\chosun\Desktop\progress report\17.02.15 progress report\siID3-MDC1,P-ID3\U2OSsiCTL-2Gy-30min_P-ID3-crop2-Image Export-22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8815" y="144242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8" descr="C:\Users\chosun\Desktop\progress report\17.02.15 progress report\siID3-MDC1,P-ID3\U2OSsiCTL-2Gy-30min_P-ID3-crop2-Image Export-22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8815" y="423777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9" descr="C:\Users\chosun\Desktop\progress report\17.02.15 progress report\siID3-MDC1,P-ID3\U2OSsiCTL-2Gy-30min_P-ID3-crop2-Image Export-22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8815" y="283240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직사각형 17"/>
          <p:cNvSpPr/>
          <p:nvPr/>
        </p:nvSpPr>
        <p:spPr>
          <a:xfrm>
            <a:off x="4313361" y="1313843"/>
            <a:ext cx="1482775" cy="2847797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179153617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0800000" flipV="1">
            <a:off x="1763688" y="620688"/>
            <a:ext cx="1956647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Nu7026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12" descr="C:\Users\chosun\Desktop\progress report\17.02.28 progress report\17.02.28 U2OS P-ID3 early time\U2OS10Gy-0min-P-ID3-crop3-Image Export-04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0135" y="134094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13" descr="C:\Users\chosun\Desktop\progress report\17.02.28 progress report\17.02.28 U2OS P-ID3 early time\U2OS10Gy-0min-P-ID3-crop3-Image Export-04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0135" y="412397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14" descr="C:\Users\chosun\Desktop\progress report\17.02.28 progress report\17.02.28 U2OS P-ID3 early time\U2OS10Gy-0min-P-ID3-crop3-Image Export-04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0135" y="27287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1475655" y="1268760"/>
            <a:ext cx="1644757" cy="2789204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  <p:sp>
        <p:nvSpPr>
          <p:cNvPr id="27" name="TextBox 26"/>
          <p:cNvSpPr txBox="1"/>
          <p:nvPr/>
        </p:nvSpPr>
        <p:spPr>
          <a:xfrm>
            <a:off x="3694950" y="597106"/>
            <a:ext cx="46839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3" descr="C:\Users\chosun\Desktop\progress report\17.06.22 U2OS P-ID3,rH2ax.mdb\UT-Rh2AXP-ID3-1-Image Export-02_c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459" y="27287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4" descr="C:\Users\chosun\Desktop\progress report\17.06.22 U2OS P-ID3,rH2ax.mdb\UT-Rh2AXP-ID3-2-Image Export-03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459" y="134094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4" descr="C:\Users\chosun\Desktop\progress report\17.06.22 U2OS P-ID3,rH2ax.mdb\UT-Rh2AXP-ID3-2-Image Export-03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459" y="412397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088480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0800000" flipV="1">
            <a:off x="2148378" y="620687"/>
            <a:ext cx="166861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Nu7026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5" descr="C:\Users\chosun\Desktop\progress report\17.02.28 progress report\17.02.28 U2OS P-ID3 early time\U2OSP-ID3-10Gy-60min-crop1-Image Export-43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0826" y="143428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6" descr="C:\Users\chosun\Desktop\progress report\17.02.28 progress report\17.02.28 U2OS P-ID3 early time\U2OSP-ID3-10Gy-60min-crop1-Image Export-43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0826" y="421501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7" descr="C:\Users\chosun\Desktop\progress report\17.02.28 progress report\17.02.28 U2OS P-ID3 early time\U2OSP-ID3-10Gy-60min-crop1-Image Export-43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0826" y="283256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3948579" y="620688"/>
            <a:ext cx="104547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30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8" descr="C:\Users\chosun\Desktop\progress report\17.02.15 progress report\siID3-MDC1,P-ID3\U2OSsiID3-2Gy-15min_P-ID3-crop1-Image Export-33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8854" y="143428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9" descr="C:\Users\chosun\Desktop\progress report\17.02.15 progress report\siID3-MDC1,P-ID3\U2OSsiID3-2Gy-15min_P-ID3-crop1-Image Export-33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8854" y="421501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0" descr="C:\Users\chosun\Desktop\progress report\17.02.15 progress report\siID3-MDC1,P-ID3\U2OSsiID3-2Gy-15min_P-ID3-crop1-Image Export-33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8357" y="283256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17" descr="C:\Users\chosun\Desktop\progress report\17.02.15 progress report\siID3-MDC1,P-ID3\U2OSsiID3-2Gy-15min_P-ID3-crop4-Image Export-36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48579" y="143428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8" descr="C:\Users\chosun\Desktop\progress report\17.02.15 progress report\siID3-MDC1,P-ID3\U2OSsiID3-2Gy-15min_P-ID3-crop4-Image Export-36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48579" y="421501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9" descr="C:\Users\chosun\Desktop\progress report\17.02.15 progress report\siID3-MDC1,P-ID3\U2OSsiID3-2Gy-15min_P-ID3-crop4-Image Export-36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9389" y="283256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직사각형 21"/>
          <p:cNvSpPr/>
          <p:nvPr/>
        </p:nvSpPr>
        <p:spPr>
          <a:xfrm>
            <a:off x="2456920" y="1340767"/>
            <a:ext cx="1472469" cy="2821027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143917621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0800000" flipV="1">
            <a:off x="2207648" y="620688"/>
            <a:ext cx="166861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Nu7026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8" descr="C:\Users\chosun\Desktop\progress report\17.02.28 progress report\17.02.28 U2OS P-ID3 early time\U2OSP-ID3-10Gy-60min-crop3-Image Export-44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2725" y="13196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9" descr="C:\Users\chosun\Desktop\progress report\17.02.28 progress report\17.02.28 U2OS P-ID3 early time\U2OSP-ID3-10Gy-60min-crop3-Image Export-44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2725" y="411206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0" descr="C:\Users\chosun\Desktop\progress report\17.02.28 progress report\17.02.28 U2OS P-ID3 early time\U2OSP-ID3-10Gy-60min-crop3-Image Export-44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2725" y="271378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4146884" y="620687"/>
            <a:ext cx="68800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1h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2" descr="C:\Users\chosun\Desktop\progress report\17.02.15 progress report\siID3-MDC1,P-ID3\U2OSsiCTL-2Gy-15min_P-ID3-crop1-Image Export-09_c1+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8301" y="411206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3" descr="C:\Users\chosun\Desktop\progress report\17.02.15 progress report\siID3-MDC1,P-ID3\U2OSsiCTL-2Gy-15min_P-ID3-crop1-Image Export-09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8301" y="271378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0" descr="C:\Users\chosun\Desktop\progress report\17.02.15 progress report\siID3-MDC1,P-ID3\U2OSsiCTL-2Gy-15min_P-ID3-crop4-Image Export-12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4148" y="13196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11" descr="C:\Users\chosun\Desktop\progress report\17.02.15 progress report\siID3-MDC1,P-ID3\U2OSsiCTL-2Gy-15min_P-ID3-crop4-Image Export-12_c1+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4148" y="411206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2" descr="C:\Users\chosun\Desktop\progress report\17.02.15 progress report\siID3-MDC1,P-ID3\U2OSsiCTL-2Gy-15min_P-ID3-crop4-Image Export-12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4148" y="271378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9" descr="C:\Users\chosun\Desktop\progress report\17.02.15 progress report\siID3-MDC1,P-ID3\U2OSsiCTL-2Gy-15min_P-ID3-crop1-Image Export-09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8301" y="13196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직사각형 10"/>
          <p:cNvSpPr/>
          <p:nvPr/>
        </p:nvSpPr>
        <p:spPr>
          <a:xfrm>
            <a:off x="1619672" y="1268760"/>
            <a:ext cx="1498629" cy="280831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325364996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0800000" flipV="1">
            <a:off x="1347395" y="702466"/>
            <a:ext cx="1596607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Nu7026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15" descr="C:\Users\chosun\Desktop\progress report\17.02.28 progress report\17.02.28 U2OS P-ID3 early time\U2OSP-ID3-10Gy-180min-crop2-Image Export-53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1530" y="140622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6" descr="C:\Users\chosun\Desktop\progress report\17.02.28 progress report\17.02.28 U2OS P-ID3 early time\U2OSP-ID3-10Gy-180min-crop2-Image Export-53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2780" y="423916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7" descr="C:\Users\chosun\Desktop\progress report\17.02.28 progress report\17.02.28 U2OS P-ID3 early time\U2OSP-ID3-10Gy-180min-crop2-Image Export-53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2780" y="282269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3203334" y="695901"/>
            <a:ext cx="68800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3h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Picture 4" descr="C:\Users\chosun\Desktop\progress report\17.02.15 progress report\siID3-MDC1,P-ID3\U2OSsiCTL-2Gy-15min_P-ID3-crop2-Image Export-10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2509" y="140622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5" descr="C:\Users\chosun\Desktop\progress report\17.02.15 progress report\siID3-MDC1,P-ID3\U2OSsiCTL-2Gy-15min_P-ID3-crop2-Image Export-10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2509" y="423916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6" descr="C:\Users\chosun\Desktop\progress report\17.02.15 progress report\siID3-MDC1,P-ID3\U2OSsiCTL-2Gy-15min_P-ID3-crop2-Image Export-10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2509" y="282269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7" descr="C:\Users\chosun\Desktop\progress report\17.02.15 progress report\siID3-MDC1,P-ID3\U2OSsiCTL-2Gy-15min_P-ID3-crop3-Image Export-11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8502" y="140622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8" descr="C:\Users\chosun\Desktop\progress report\17.02.15 progress report\siID3-MDC1,P-ID3\U2OSsiCTL-2Gy-15min_P-ID3-crop3-Image Export-11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8502" y="423916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9" descr="C:\Users\chosun\Desktop\progress report\17.02.15 progress report\siID3-MDC1,P-ID3\U2OSsiCTL-2Gy-15min_P-ID3-crop3-Image Export-11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6661" y="282269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직사각형 25"/>
          <p:cNvSpPr/>
          <p:nvPr/>
        </p:nvSpPr>
        <p:spPr>
          <a:xfrm>
            <a:off x="611560" y="1340768"/>
            <a:ext cx="1408484" cy="281116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84406" tIns="42203" rIns="84406" bIns="4220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34436980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hahahamj\Desktop\새 폴더 (2)\U2OS rH2AX,P-ID3\U2OS-rH2AXP-ID3-3hr-1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4383" y="222689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hahahamj\Desktop\새 폴더 (2)\U2OS rH2AX,P-ID3\U2OS-rH2AXP-ID3-3hr-1_c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376126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hahahamj\Desktop\새 폴더 (2)\U2OS rH2AX,P-ID3\U2OS-rH2AXP-ID3-3hr-2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753" y="69269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hahahamj\Desktop\새 폴더 (2)\U2OS rH2AX,P-ID3\U2OS-rH2AXP-ID3-3hr-2_c1+2+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863" y="53467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hahahamj\Desktop\새 폴더 (2)\U2OS rH2AX,P-ID3\U2OS-rH2AXP-ID3-3hr-2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863" y="220987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hahahamj\Desktop\새 폴더 (2)\U2OS rH2AX,P-ID3\U2OS-rH2AXP-ID3-3hr-2_c3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753" y="37605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hahahamj\Desktop\새 폴더 (2)\U2OS rH2AX,P-ID3\U2OS-rH2AXP-ID3-3hr-3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5871" y="69269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C:\Users\hahahamj\Desktop\새 폴더 (2)\U2OS rH2AX,P-ID3\U2OS-rH2AXP-ID3-3hr-3_c1+2+3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5871" y="53467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C:\Users\hahahamj\Desktop\새 폴더 (2)\U2OS rH2AX,P-ID3\U2OS-rH2AXP-ID3-3hr-3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5871" y="22108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9" name="Picture 11" descr="C:\Users\hahahamj\Desktop\새 폴더 (2)\U2OS rH2AX,P-ID3\U2OS-rH2AXP-ID3-3hr-3_c3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5871" y="37605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 descr="C:\Users\hahahamj\Desktop\새 폴더 (2)\U2OS rH2AX,P-ID3\U2OS-rH2AXP-ID3-3hr-4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879" y="69870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1" name="Picture 13" descr="C:\Users\hahahamj\Desktop\새 폴더 (2)\U2OS rH2AX,P-ID3\U2OS-rH2AXP-ID3-3hr-4_c1+2+3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879" y="53467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2" name="Picture 14" descr="C:\Users\hahahamj\Desktop\새 폴더 (2)\U2OS rH2AX,P-ID3\U2OS-rH2AXP-ID3-3hr-4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879" y="222689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3" name="Picture 15" descr="C:\Users\hahahamj\Desktop\새 폴더 (2)\U2OS rH2AX,P-ID3\U2OS-rH2AXP-ID3-3hr-4_c3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879" y="37605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4" name="Picture 16" descr="C:\Users\hahahamj\Desktop\새 폴더 (2)\U2OS rH2AX,P-ID3\U2OS-rH2AXP-ID3-3hr-5_c1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0047" y="69870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5" name="Picture 17" descr="C:\Users\hahahamj\Desktop\새 폴더 (2)\U2OS rH2AX,P-ID3\U2OS-rH2AXP-ID3-3hr-5_c1+2+3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0047" y="53467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6" name="Picture 18" descr="C:\Users\hahahamj\Desktop\새 폴더 (2)\U2OS rH2AX,P-ID3\U2OS-rH2AXP-ID3-3hr-5_c2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0047" y="22108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7" name="Picture 19" descr="C:\Users\hahahamj\Desktop\새 폴더 (2)\U2OS rH2AX,P-ID3\U2OS-rH2AXP-ID3-3hr-5_c3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0047" y="37605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8" name="Picture 20" descr="C:\Users\hahahamj\Desktop\새 폴더 (2)\U2OS rH2AX,P-ID3\U2OS-rH2AXP-ID3-3hr-6_c1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2375" y="69870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9" name="Picture 21" descr="C:\Users\hahahamj\Desktop\새 폴더 (2)\U2OS rH2AX,P-ID3\U2OS-rH2AXP-ID3-3hr-6_c1+2+3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2375" y="53467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0" name="Picture 22" descr="C:\Users\hahahamj\Desktop\새 폴더 (2)\U2OS rH2AX,P-ID3\U2OS-rH2AXP-ID3-3hr-6_c2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2292" y="22108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1" name="Picture 23" descr="C:\Users\hahahamj\Desktop\새 폴더 (2)\U2OS rH2AX,P-ID3\U2OS-rH2AXP-ID3-3hr-6_c3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2375" y="376057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2" name="Picture 24" descr="C:\Users\hahahamj\Desktop\새 폴더 (2)\U2OS rH2AX,P-ID3\U2OS-rH2AXP-ID3-3hr-1_c1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4383" y="69870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3" name="Picture 25" descr="C:\Users\hahahamj\Desktop\새 폴더 (2)\U2OS rH2AX,P-ID3\U2OS-rH2AXP-ID3-3hr-1_c1+2+3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4383" y="534678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7214" y="237292"/>
            <a:ext cx="42562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1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3755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hahahamj\Desktop\새 폴더 (2)\U2OS rH2AX,P-ID3\U2OS-rH2AXP-ID3-6hr-1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0356" y="22768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hahahamj\Desktop\새 폴더 (2)\U2OS rH2AX,P-ID3\U2OS-rH2AXP-ID3-6hr-1_c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34689" y="378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C:\Users\hahahamj\Desktop\새 폴더 (2)\U2OS rH2AX,P-ID3\U2OS-rH2AXP-ID3-6hr-2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7648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hahahamj\Desktop\새 폴더 (2)\U2OS rH2AX,P-ID3\U2OS-rH2AXP-ID3-6hr-2_c1+2+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441" y="535364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C:\Users\hahahamj\Desktop\새 폴더 (2)\U2OS rH2AX,P-ID3\U2OS-rH2AXP-ID3-6hr-2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227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9" name="Picture 7" descr="C:\Users\hahahamj\Desktop\새 폴더 (2)\U2OS rH2AX,P-ID3\U2OS-rH2AXP-ID3-6hr-2_c3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378287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C:\Users\hahahamj\Desktop\새 폴더 (2)\U2OS rH2AX,P-ID3\U2OS-rH2AXP-ID3-6hr-3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832" y="7648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 descr="C:\Users\hahahamj\Desktop\새 폴더 (2)\U2OS rH2AX,P-ID3\U2OS-rH2AXP-ID3-6hr-3_c1+2+3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832" y="53494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2" name="Picture 10" descr="C:\Users\hahahamj\Desktop\새 폴더 (2)\U2OS rH2AX,P-ID3\U2OS-rH2AXP-ID3-6hr-3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832" y="227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3" name="Picture 11" descr="C:\Users\hahahamj\Desktop\새 폴더 (2)\U2OS rH2AX,P-ID3\U2OS-rH2AXP-ID3-6hr-3_c3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832" y="378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 descr="C:\Users\hahahamj\Desktop\새 폴더 (2)\U2OS rH2AX,P-ID3\U2OS-rH2AXP-ID3-6hr-4_c1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000" y="7648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5" name="Picture 13" descr="C:\Users\hahahamj\Desktop\새 폴더 (2)\U2OS rH2AX,P-ID3\U2OS-rH2AXP-ID3-6hr-4_c1+2+3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000" y="53494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6" name="Picture 14" descr="C:\Users\hahahamj\Desktop\새 폴더 (2)\U2OS rH2AX,P-ID3\U2OS-rH2AXP-ID3-6hr-4_c2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000" y="227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7" name="Picture 15" descr="C:\Users\hahahamj\Desktop\새 폴더 (2)\U2OS rH2AX,P-ID3\U2OS-rH2AXP-ID3-6hr-4_c3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000" y="378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8" name="Picture 16" descr="C:\Users\hahahamj\Desktop\새 폴더 (2)\U2OS rH2AX,P-ID3\U2OS-rH2AXP-ID3-6hr-5_c1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168" y="7648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9" name="Picture 17" descr="C:\Users\hahahamj\Desktop\새 폴더 (2)\U2OS rH2AX,P-ID3\U2OS-rH2AXP-ID3-6hr-5_c1+2+3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168" y="53494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0" name="Picture 18" descr="C:\Users\hahahamj\Desktop\새 폴더 (2)\U2OS rH2AX,P-ID3\U2OS-rH2AXP-ID3-6hr-5_c2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168" y="227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1" name="Picture 19" descr="C:\Users\hahahamj\Desktop\새 폴더 (2)\U2OS rH2AX,P-ID3\U2OS-rH2AXP-ID3-6hr-5_c3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168" y="378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2" name="Picture 20" descr="C:\Users\hahahamj\Desktop\새 폴더 (2)\U2OS rH2AX,P-ID3\U2OS-rH2AXP-ID3-6hr-6_c1.jpg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9385" y="7648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3" name="Picture 21" descr="C:\Users\hahahamj\Desktop\새 폴더 (2)\U2OS rH2AX,P-ID3\U2OS-rH2AXP-ID3-6hr-6_c1+2+3.jpg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3671" y="53494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4" name="Picture 22" descr="C:\Users\hahahamj\Desktop\새 폴더 (2)\U2OS rH2AX,P-ID3\U2OS-rH2AXP-ID3-6hr-6_c2.jpg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9385" y="22768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5" name="Picture 23" descr="C:\Users\hahahamj\Desktop\새 폴더 (2)\U2OS rH2AX,P-ID3\U2OS-rH2AXP-ID3-6hr-6_c3.jpg"/>
          <p:cNvPicPr>
            <a:picLocks noChangeAspect="1" noChangeArrowheads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3671" y="378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6" name="Picture 24" descr="C:\Users\hahahamj\Desktop\새 폴더 (2)\U2OS rH2AX,P-ID3\U2OS-rH2AXP-ID3-6hr-1_c1.jpg"/>
          <p:cNvPicPr>
            <a:picLocks noChangeAspect="1"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53571" y="75111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7" name="Picture 25" descr="C:\Users\hahahamj\Desktop\새 폴더 (2)\U2OS rH2AX,P-ID3\U2OS-rH2AXP-ID3-6hr-1_c1+2+3.jpg"/>
          <p:cNvPicPr>
            <a:picLocks noChangeAspect="1" noChangeArrowheads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6336" y="537321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7214" y="237292"/>
            <a:ext cx="43412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3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3755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94040" y="2132856"/>
            <a:ext cx="4663456" cy="2554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</a:p>
          <a:p>
            <a:pPr algn="ctr"/>
            <a:r>
              <a:rPr lang="en-US" altLang="ko-KR" sz="3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KU55933 (ATM inhibitor)</a:t>
            </a:r>
          </a:p>
          <a:p>
            <a:pPr algn="ctr"/>
            <a:endParaRPr lang="en-US" altLang="ko-KR" sz="3200" dirty="0" smtClean="0">
              <a:solidFill>
                <a:srgbClr val="0066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3200" dirty="0" smtClean="0">
                <a:solidFill>
                  <a:srgbClr val="00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pPr algn="ctr"/>
            <a:r>
              <a:rPr lang="en-US" altLang="ko-KR" sz="3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3755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hahahamj\Desktop\새 폴더 (2)\U2OS rH2AX,P-ID3-KU 사진\U2OS-KU-rH2AXP-ID3-0hr-5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227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hahahamj\Desktop\새 폴더 (2)\U2OS rH2AX,P-ID3-KU 사진\U2OS-KU-rH2AXP-ID3-0hr-5_c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37800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hahahamj\Desktop\새 폴더 (2)\U2OS rH2AX,P-ID3-KU 사진\U2OS-KU-rH2AXP-ID3-0hr-6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621" y="71395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hahahamj\Desktop\새 폴더 (2)\U2OS rH2AX,P-ID3-KU 사진\U2OS-KU-rH2AXP-ID3-0hr-6_c1+2+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621" y="53013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hahahamj\Desktop\새 폴더 (2)\U2OS rH2AX,P-ID3-KU 사진\U2OS-KU-rH2AXP-ID3-0hr-6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621" y="227143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hahahamj\Desktop\새 폴더 (2)\U2OS rH2AX,P-ID3-KU 사진\U2OS-KU-rH2AXP-ID3-0hr-6_c3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621" y="376749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hahahamj\Desktop\새 폴더 (2)\U2OS rH2AX,P-ID3-KU 사진\U2OS-KU-rH2AXP-ID3-0hr-1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9685" y="71395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hahahamj\Desktop\새 폴더 (2)\U2OS rH2AX,P-ID3-KU 사진\U2OS-KU-rH2AXP-ID3-0hr-1_c1+2+3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9575" y="529191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hahahamj\Desktop\새 폴더 (2)\U2OS rH2AX,P-ID3-KU 사진\U2OS-KU-rH2AXP-ID3-0hr-1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7789" y="227373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C:\Users\hahahamj\Desktop\새 폴더 (2)\U2OS rH2AX,P-ID3-KU 사진\U2OS-KU-rH2AXP-ID3-0hr-1_c3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9685" y="37892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C:\Users\hahahamj\Desktop\새 폴더 (2)\U2OS rH2AX,P-ID3-KU 사진\U2OS-KU-rH2AXP-ID3-0hr-2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160" y="7341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7" name="Picture 13" descr="C:\Users\hahahamj\Desktop\새 폴더 (2)\U2OS rH2AX,P-ID3-KU 사진\U2OS-KU-rH2AXP-ID3-0hr-2_c1+2+3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797" y="53013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C:\Users\hahahamj\Desktop\새 폴더 (2)\U2OS rH2AX,P-ID3-KU 사진\U2OS-KU-rH2AXP-ID3-0hr-2_c2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9769" y="227373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9" name="Picture 15" descr="C:\Users\hahahamj\Desktop\새 폴더 (2)\U2OS rH2AX,P-ID3-KU 사진\U2OS-KU-rH2AXP-ID3-0hr-2_c3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797" y="378920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C:\Users\hahahamj\Desktop\새 폴더 (2)\U2OS rH2AX,P-ID3-KU 사진\U2OS-KU-rH2AXP-ID3-0hr-3_c1+2+3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168" y="529191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1" name="Picture 17" descr="C:\Users\hahahamj\Desktop\새 폴더 (2)\U2OS rH2AX,P-ID3-KU 사진\U2OS-KU-rH2AXP-ID3-0hr-4_c1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336" y="76029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C:\Users\hahahamj\Desktop\새 폴더 (2)\U2OS rH2AX,P-ID3-KU 사진\U2OS-KU-rH2AXP-ID3-0hr-4_c1+2+3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7545" y="529191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3" name="Picture 19" descr="C:\Users\hahahamj\Desktop\새 폴더 (2)\U2OS rH2AX,P-ID3-KU 사진\U2OS-KU-rH2AXP-ID3-0hr-4_c2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336" y="227143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C:\Users\hahahamj\Desktop\새 폴더 (2)\U2OS rH2AX,P-ID3-KU 사진\U2OS-KU-rH2AXP-ID3-0hr-4_c3.jpg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336" y="37800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5" name="Picture 21" descr="C:\Users\hahahamj\Desktop\새 폴더 (2)\U2OS rH2AX,P-ID3-KU 사진\U2OS-KU-rH2AXP-ID3-0hr-5_c1.jpg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5291205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6" name="Picture 22" descr="C:\Users\hahahamj\Desktop\새 폴더 (2)\U2OS rH2AX,P-ID3-KU 사진\U2OS-KU-rH2AXP-ID3-0hr-5_c1+2+3.jpg"/>
          <p:cNvPicPr>
            <a:picLocks noChangeAspect="1" noChangeArrowheads="1"/>
          </p:cNvPicPr>
          <p:nvPr/>
        </p:nvPicPr>
        <p:blipFill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76675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7" name="Picture 23" descr="C:\Users\hahahamj\Desktop\새 폴더 (2)\U2OS rH2AX,P-ID3-KU 사진\U2OS-KU-rH2AXP-ID3-0hr-3_c3.jpg"/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168" y="375760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8" name="Picture 24" descr="C:\Users\hahahamj\Desktop\새 폴더 (2)\U2OS rH2AX,P-ID3-KU 사진\U2OS-KU-rH2AXP-ID3-0hr-3_c1.jpg"/>
          <p:cNvPicPr>
            <a:picLocks noChangeAspect="1"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168" y="76029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9" name="Picture 25" descr="C:\Users\hahahamj\Desktop\새 폴더 (2)\U2OS rH2AX,P-ID3-KU 사진\U2OS-KU-rH2AXP-ID3-0hr-3_c2.jpg"/>
          <p:cNvPicPr>
            <a:picLocks noChangeAspect="1"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1228" y="227143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147214" y="237292"/>
            <a:ext cx="48718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0hr(UT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375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hahahamj\Desktop\새 폴더 (2)\U2OS rH2AX,P-ID3-KU 사진\U2OS-KU-rH2AXP-ID3-3hr-6_c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37694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hahahamj\Desktop\새 폴더 (2)\U2OS rH2AX,P-ID3-KU 사진\U2OS-KU-rH2AXP-ID3-3hr-1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413" y="71468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hahahamj\Desktop\새 폴더 (2)\U2OS rH2AX,P-ID3-KU 사진\U2OS-KU-rH2AXP-ID3-3hr-1_c1+2+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4474" y="530220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hahahamj\Desktop\새 폴더 (2)\U2OS rH2AX,P-ID3-KU 사진\U2OS-KU-rH2AXP-ID3-3hr-1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5164" y="225379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hahahamj\Desktop\새 폴더 (2)\U2OS rH2AX,P-ID3-KU 사진\U2OS-KU-rH2AXP-ID3-3hr-1_c3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5164" y="375643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hahahamj\Desktop\새 폴더 (2)\U2OS rH2AX,P-ID3-KU 사진\U2OS-KU-rH2AXP-ID3-3hr-2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836" y="7103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hahahamj\Desktop\새 폴더 (2)\U2OS rH2AX,P-ID3-KU 사진\U2OS-KU-rH2AXP-ID3-3hr-2_c1+2+3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419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C:\Users\hahahamj\Desktop\새 폴더 (2)\U2OS rH2AX,P-ID3-KU 사진\U2OS-KU-rH2AXP-ID3-3hr-2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419" y="225581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C:\Users\hahahamj\Desktop\새 폴더 (2)\U2OS rH2AX,P-ID3-KU 사진\U2OS-KU-rH2AXP-ID3-3hr-2_c3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836" y="376947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9" name="Picture 11" descr="C:\Users\hahahamj\Desktop\새 폴더 (2)\U2OS rH2AX,P-ID3-KU 사진\U2OS-KU-rH2AXP-ID3-3hr-3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2965" y="7103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 descr="C:\Users\hahahamj\Desktop\새 폴더 (2)\U2OS rH2AX,P-ID3-KU 사진\U2OS-KU-rH2AXP-ID3-3hr-3_c1+2+3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2965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1" name="Picture 13" descr="C:\Users\hahahamj\Desktop\새 폴더 (2)\U2OS rH2AX,P-ID3-KU 사진\U2OS-KU-rH2AXP-ID3-3hr-3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7332" y="22451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2" name="Picture 14" descr="C:\Users\hahahamj\Desktop\새 폴더 (2)\U2OS rH2AX,P-ID3-KU 사진\U2OS-KU-rH2AXP-ID3-3hr-3_c3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7332" y="375457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3" name="Picture 15" descr="C:\Users\hahahamj\Desktop\새 폴더 (2)\U2OS rH2AX,P-ID3-KU 사진\U2OS-KU-rH2AXP-ID3-3hr-4_c1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0696" y="7103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4" name="Picture 16" descr="C:\Users\hahahamj\Desktop\새 폴더 (2)\U2OS rH2AX,P-ID3-KU 사진\U2OS-KU-rH2AXP-ID3-3hr-4_c1+2+3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9340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5" name="Picture 17" descr="C:\Users\hahahamj\Desktop\새 폴더 (2)\U2OS rH2AX,P-ID3-KU 사진\U2OS-KU-rH2AXP-ID3-3hr-4_c2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9340" y="225581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6" name="Picture 18" descr="C:\Users\hahahamj\Desktop\새 폴더 (2)\U2OS rH2AX,P-ID3-KU 사진\U2OS-KU-rH2AXP-ID3-3hr-4_c3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0696" y="375457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7" name="Picture 19" descr="C:\Users\hahahamj\Desktop\새 폴더 (2)\U2OS rH2AX,P-ID3-KU 사진\U2OS-KU-rH2AXP-ID3-3hr-5_c1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3363" y="7103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8" name="Picture 20" descr="C:\Users\hahahamj\Desktop\새 폴더 (2)\U2OS rH2AX,P-ID3-KU 사진\U2OS-KU-rH2AXP-ID3-3hr-5_c1+2+3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2704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9" name="Picture 21" descr="C:\Users\hahahamj\Desktop\새 폴더 (2)\U2OS rH2AX,P-ID3-KU 사진\U2OS-KU-rH2AXP-ID3-3hr-5_c2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3363" y="225581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0" name="Picture 22" descr="C:\Users\hahahamj\Desktop\새 폴더 (2)\U2OS rH2AX,P-ID3-KU 사진\U2OS-KU-rH2AXP-ID3-3hr-5_c3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3363" y="375457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1" name="Picture 23" descr="C:\Users\hahahamj\Desktop\새 폴더 (2)\U2OS rH2AX,P-ID3-KU 사진\U2OS-KU-rH2AXP-ID3-3hr-6_c1.jpg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7824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2" name="Picture 24" descr="C:\Users\hahahamj\Desktop\새 폴더 (2)\U2OS rH2AX,P-ID3-KU 사진\U2OS-KU-rH2AXP-ID3-3hr-6_c1+2+3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55371" y="5302209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3" name="Picture 25" descr="C:\Users\hahahamj\Desktop\새 폴더 (2)\U2OS rH2AX,P-ID3-KU 사진\U2OS-KU-rH2AXP-ID3-3hr-6_c2.jpg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4" y="229457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7214" y="237292"/>
            <a:ext cx="42562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1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3755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hahahamj\Desktop\새 폴더 (2)\U2OS rH2AX,P-ID3-KU 사진\U2OS-KU-rH2AXP-ID3-6hr-3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31" y="227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hahahamj\Desktop\새 폴더 (2)\U2OS rH2AX,P-ID3-KU 사진\U2OS-KU-rH2AXP-ID3-6hr-3_c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02" y="37814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C:\Users\hahahamj\Desktop\새 폴더 (2)\U2OS rH2AX,P-ID3-KU 사진\U2OS-KU-rH2AXP-ID3-6hr-4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8779" y="7405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hahahamj\Desktop\새 폴더 (2)\U2OS rH2AX,P-ID3-KU 사진\U2OS-KU-rH2AXP-ID3-6hr-4_c1+2+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8779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C:\Users\hahahamj\Desktop\새 폴더 (2)\U2OS rH2AX,P-ID3-KU 사진\U2OS-KU-rH2AXP-ID3-6hr-4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8779" y="22825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9" name="Picture 7" descr="C:\Users\hahahamj\Desktop\새 폴더 (2)\U2OS rH2AX,P-ID3-KU 사진\U2OS-KU-rH2AXP-ID3-6hr-4_c3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8779" y="37804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C:\Users\hahahamj\Desktop\새 폴더 (2)\U2OS rH2AX,P-ID3-KU 사진\U2OS-KU-rH2AXP-ID3-6hr-5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6611" y="7405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 descr="C:\Users\hahahamj\Desktop\새 폴더 (2)\U2OS rH2AX,P-ID3-KU 사진\U2OS-KU-rH2AXP-ID3-6hr-5_c1+2+3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6611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2" name="Picture 10" descr="C:\Users\hahahamj\Desktop\새 폴더 (2)\U2OS rH2AX,P-ID3-KU 사진\U2OS-KU-rH2AXP-ID3-6hr-5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6611" y="22768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3" name="Picture 11" descr="C:\Users\hahahamj\Desktop\새 폴더 (2)\U2OS rH2AX,P-ID3-KU 사진\U2OS-KU-rH2AXP-ID3-6hr-5_c3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6611" y="37804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 descr="C:\Users\hahahamj\Desktop\새 폴더 (2)\U2OS rH2AX,P-ID3-KU 사진\U2OS-KU-rH2AXP-ID3-6hr-6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7413" y="75294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5" name="Picture 13" descr="C:\Users\hahahamj\Desktop\새 폴더 (2)\U2OS rH2AX,P-ID3-KU 사진\U2OS-KU-rH2AXP-ID3-6hr-6_c1+2+3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7413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6" name="Picture 14" descr="C:\Users\hahahamj\Desktop\새 폴더 (2)\U2OS rH2AX,P-ID3-KU 사진\U2OS-KU-rH2AXP-ID3-6hr-6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6047" y="2282586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7" name="Picture 15" descr="C:\Users\hahahamj\Desktop\새 폴더 (2)\U2OS rH2AX,P-ID3-KU 사진\U2OS-KU-rH2AXP-ID3-6hr-6_c3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7413" y="37804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8" name="Picture 16" descr="C:\Users\hahahamj\Desktop\새 폴더 (2)\U2OS rH2AX,P-ID3-KU 사진\U2OS-KU-rH2AXP-ID3-6hr-1_c1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2435" y="75237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9" name="Picture 17" descr="C:\Users\hahahamj\Desktop\새 폴더 (2)\U2OS rH2AX,P-ID3-KU 사진\U2OS-KU-rH2AXP-ID3-6hr-1_c1+2+3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2275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0" name="Picture 18" descr="C:\Users\hahahamj\Desktop\새 폴더 (2)\U2OS rH2AX,P-ID3-KU 사진\U2OS-KU-rH2AXP-ID3-6hr-1_c2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2435" y="227687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1" name="Picture 19" descr="C:\Users\hahahamj\Desktop\새 폴더 (2)\U2OS rH2AX,P-ID3-KU 사진\U2OS-KU-rH2AXP-ID3-6hr-1_c3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2275" y="37890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2" name="Picture 20" descr="C:\Users\hahahamj\Desktop\새 폴더 (2)\U2OS rH2AX,P-ID3-KU 사진\U2OS-KU-rH2AXP-ID3-6hr-2_c1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8897" y="7489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3" name="Picture 21" descr="C:\Users\hahahamj\Desktop\새 폴더 (2)\U2OS rH2AX,P-ID3-KU 사진\U2OS-KU-rH2AXP-ID3-6hr-2_c1+2+3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4556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4" name="Picture 22" descr="C:\Users\hahahamj\Desktop\새 폴더 (2)\U2OS rH2AX,P-ID3-KU 사진\U2OS-KU-rH2AXP-ID3-6hr-2_c2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6267" y="227703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5" name="Picture 23" descr="C:\Users\hahahamj\Desktop\새 폴더 (2)\U2OS rH2AX,P-ID3-KU 사진\U2OS-KU-rH2AXP-ID3-6hr-2_c3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6267" y="378149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6" name="Picture 24" descr="C:\Users\hahahamj\Desktop\새 폴더 (2)\U2OS rH2AX,P-ID3-KU 사진\U2OS-KU-rH2AXP-ID3-6hr-3_c1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02" y="764864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7" name="Picture 25" descr="C:\Users\hahahamj\Desktop\새 폴더 (2)\U2OS rH2AX,P-ID3-KU 사진\U2OS-KU-rH2AXP-ID3-6hr-3_c1+2+3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02" y="530120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7214" y="237292"/>
            <a:ext cx="42562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2400" dirty="0" smtClean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3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3209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71932" y="2132856"/>
            <a:ext cx="5307671" cy="2554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</a:p>
          <a:p>
            <a:pPr algn="ctr"/>
            <a:r>
              <a:rPr lang="en-US" altLang="ko-KR" sz="3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NU7441 (DNA-PK inhibitor)</a:t>
            </a:r>
          </a:p>
          <a:p>
            <a:pPr algn="ctr"/>
            <a:endParaRPr lang="en-US" altLang="ko-KR" sz="3200" dirty="0" smtClean="0">
              <a:solidFill>
                <a:srgbClr val="0066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3200" dirty="0" smtClean="0">
                <a:solidFill>
                  <a:srgbClr val="00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2AX</a:t>
            </a:r>
          </a:p>
          <a:p>
            <a:pPr algn="ctr"/>
            <a:r>
              <a:rPr lang="en-US" altLang="ko-KR" sz="3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320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132</Words>
  <Application>Microsoft Office PowerPoint</Application>
  <PresentationFormat>화면 슬라이드 쇼(4:3)</PresentationFormat>
  <Paragraphs>47</Paragraphs>
  <Slides>24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4</vt:i4>
      </vt:variant>
    </vt:vector>
  </HeadingPairs>
  <TitlesOfParts>
    <vt:vector size="2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hahamj</dc:creator>
  <cp:lastModifiedBy>chosun</cp:lastModifiedBy>
  <cp:revision>13</cp:revision>
  <dcterms:created xsi:type="dcterms:W3CDTF">2013-05-04T07:56:03Z</dcterms:created>
  <dcterms:modified xsi:type="dcterms:W3CDTF">2018-05-02T12:52:24Z</dcterms:modified>
</cp:coreProperties>
</file>